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media/image5.wmf" ContentType="image/x-wmf"/>
  <Override PartName="/ppt/media/image6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7099300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9FDD03-2C93-444A-8241-82700D9DF8B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36934C-03C8-474A-8119-ED446DBD2C9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926F93-320E-4CDD-BEC0-4C4D5D48145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D06FE7-E41D-4EAB-92F6-0A65B845410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9F0C09-A5F3-477A-807D-72595A1E175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F6CA8A-3E47-47C4-A1A0-C469493DE35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D041E5-26DC-4F22-8BE6-EA5BBC70518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764323-ED31-4B6D-80F9-0ED3616E1D3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BECC6E-C020-48C1-81A6-5FC56A7BF4B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6A0249-FA9E-4066-9E52-8E5DB0420FD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974C91-A40B-4853-839C-94ACE30F514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B4DDDA-AABA-47AC-9B32-088C0D253FB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53AABE0-0C3A-4997-84E1-6316A834CE50}" type="slidenum">
              <a:rPr b="0" lang="es-E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wmf"/><Relationship Id="rId4" Type="http://schemas.openxmlformats.org/officeDocument/2006/relationships/image" Target="../media/image4.wmf"/><Relationship Id="rId5" Type="http://schemas.openxmlformats.org/officeDocument/2006/relationships/image" Target="../media/image5.wmf"/><Relationship Id="rId6" Type="http://schemas.openxmlformats.org/officeDocument/2006/relationships/image" Target="../media/image6.wmf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2397240" y="5262480"/>
            <a:ext cx="63360" cy="63720"/>
            <a:chOff x="2397240" y="5262480"/>
            <a:chExt cx="63360" cy="63720"/>
          </a:xfrm>
        </p:grpSpPr>
        <p:sp>
          <p:nvSpPr>
            <p:cNvPr id="42" name=""/>
            <p:cNvSpPr/>
            <p:nvPr/>
          </p:nvSpPr>
          <p:spPr>
            <a:xfrm>
              <a:off x="2397240" y="5262480"/>
              <a:ext cx="63360" cy="63720"/>
            </a:xfrm>
            <a:prstGeom prst="ellipse">
              <a:avLst/>
            </a:prstGeom>
            <a:solidFill>
              <a:srgbClr val="80808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" bIns="-1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"/>
            <p:cNvSpPr/>
            <p:nvPr/>
          </p:nvSpPr>
          <p:spPr>
            <a:xfrm>
              <a:off x="2397240" y="5262480"/>
              <a:ext cx="63360" cy="63720"/>
            </a:xfrm>
            <a:prstGeom prst="ellipse">
              <a:avLst/>
            </a:prstGeom>
            <a:noFill/>
            <a:ln cap="rnd"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" bIns="-1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44" name="" descr=""/>
          <p:cNvPicPr/>
          <p:nvPr/>
        </p:nvPicPr>
        <p:blipFill>
          <a:blip r:embed="rId1"/>
          <a:stretch/>
        </p:blipFill>
        <p:spPr>
          <a:xfrm>
            <a:off x="487440" y="765000"/>
            <a:ext cx="1295280" cy="1295640"/>
          </a:xfrm>
          <a:prstGeom prst="rect">
            <a:avLst/>
          </a:prstGeom>
          <a:ln w="0">
            <a:noFill/>
          </a:ln>
        </p:spPr>
      </p:pic>
      <p:pic>
        <p:nvPicPr>
          <p:cNvPr id="45" name="" descr=""/>
          <p:cNvPicPr/>
          <p:nvPr/>
        </p:nvPicPr>
        <p:blipFill>
          <a:blip r:embed="rId2"/>
          <a:stretch/>
        </p:blipFill>
        <p:spPr>
          <a:xfrm>
            <a:off x="487440" y="2060640"/>
            <a:ext cx="1295280" cy="1295280"/>
          </a:xfrm>
          <a:prstGeom prst="rect">
            <a:avLst/>
          </a:prstGeom>
          <a:ln w="0">
            <a:noFill/>
          </a:ln>
        </p:spPr>
      </p:pic>
      <p:pic>
        <p:nvPicPr>
          <p:cNvPr id="46" name="" descr=""/>
          <p:cNvPicPr/>
          <p:nvPr/>
        </p:nvPicPr>
        <p:blipFill>
          <a:blip r:embed="rId3"/>
          <a:stretch/>
        </p:blipFill>
        <p:spPr>
          <a:xfrm>
            <a:off x="3081240" y="765000"/>
            <a:ext cx="1295640" cy="1295640"/>
          </a:xfrm>
          <a:prstGeom prst="rect">
            <a:avLst/>
          </a:prstGeom>
          <a:ln w="0">
            <a:noFill/>
          </a:ln>
        </p:spPr>
      </p:pic>
      <p:pic>
        <p:nvPicPr>
          <p:cNvPr id="47" name="" descr=""/>
          <p:cNvPicPr/>
          <p:nvPr/>
        </p:nvPicPr>
        <p:blipFill>
          <a:blip r:embed="rId4"/>
          <a:stretch/>
        </p:blipFill>
        <p:spPr>
          <a:xfrm>
            <a:off x="3081240" y="2060640"/>
            <a:ext cx="1295640" cy="1295280"/>
          </a:xfrm>
          <a:prstGeom prst="rect">
            <a:avLst/>
          </a:prstGeom>
          <a:ln w="0">
            <a:noFill/>
          </a:ln>
        </p:spPr>
      </p:pic>
      <p:pic>
        <p:nvPicPr>
          <p:cNvPr id="48" name="" descr=""/>
          <p:cNvPicPr/>
          <p:nvPr/>
        </p:nvPicPr>
        <p:blipFill>
          <a:blip r:embed="rId5"/>
          <a:stretch/>
        </p:blipFill>
        <p:spPr>
          <a:xfrm>
            <a:off x="1784520" y="2060640"/>
            <a:ext cx="1295280" cy="1295280"/>
          </a:xfrm>
          <a:prstGeom prst="rect">
            <a:avLst/>
          </a:prstGeom>
          <a:ln w="0">
            <a:noFill/>
          </a:ln>
        </p:spPr>
      </p:pic>
      <p:pic>
        <p:nvPicPr>
          <p:cNvPr id="49" name="" descr=""/>
          <p:cNvPicPr/>
          <p:nvPr/>
        </p:nvPicPr>
        <p:blipFill>
          <a:blip r:embed="rId6"/>
          <a:stretch/>
        </p:blipFill>
        <p:spPr>
          <a:xfrm>
            <a:off x="1784520" y="765000"/>
            <a:ext cx="1295280" cy="1295640"/>
          </a:xfrm>
          <a:prstGeom prst="rect">
            <a:avLst/>
          </a:prstGeom>
          <a:ln w="0">
            <a:noFill/>
          </a:ln>
        </p:spPr>
      </p:pic>
      <p:sp>
        <p:nvSpPr>
          <p:cNvPr id="50" name=""/>
          <p:cNvSpPr/>
          <p:nvPr/>
        </p:nvSpPr>
        <p:spPr>
          <a:xfrm>
            <a:off x="703800" y="3306600"/>
            <a:ext cx="813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ontro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2233080" y="3306600"/>
            <a:ext cx="37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5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3470760" y="3306600"/>
            <a:ext cx="478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5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 rot="16200000">
            <a:off x="-39240" y="1280520"/>
            <a:ext cx="674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6600"/>
                </a:solidFill>
                <a:latin typeface="Arial"/>
              </a:rPr>
              <a:t>MAP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 rot="16200000">
            <a:off x="-88560" y="2558160"/>
            <a:ext cx="773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400" spc="-1" strike="noStrike">
                <a:solidFill>
                  <a:srgbClr val="0000ff"/>
                </a:solidFill>
                <a:latin typeface="Arial"/>
              </a:rPr>
              <a:t>Wnt-5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117360" y="692280"/>
            <a:ext cx="3650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117360" y="3990960"/>
            <a:ext cx="3650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4421520" y="700200"/>
            <a:ext cx="307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955800" y="4065480"/>
            <a:ext cx="0" cy="1800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955800" y="5811840"/>
            <a:ext cx="30956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917640" y="4105440"/>
            <a:ext cx="363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917640" y="4389480"/>
            <a:ext cx="363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917640" y="4673520"/>
            <a:ext cx="363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917640" y="4957920"/>
            <a:ext cx="363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917640" y="5241960"/>
            <a:ext cx="363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917640" y="5526000"/>
            <a:ext cx="363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905040" y="5811840"/>
            <a:ext cx="53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917640" y="5811840"/>
            <a:ext cx="363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 rot="16200000">
            <a:off x="370440" y="4785480"/>
            <a:ext cx="24768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000000"/>
                </a:solidFill>
                <a:latin typeface="Arial"/>
              </a:rPr>
              <a:t>OD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1138320" y="5846760"/>
            <a:ext cx="48852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pCDNA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1720800" y="5846760"/>
            <a:ext cx="46872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100" spc="-1" strike="noStrike">
                <a:solidFill>
                  <a:srgbClr val="000000"/>
                </a:solidFill>
                <a:latin typeface="Arial"/>
              </a:rPr>
              <a:t>Wnt-5a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2280960" y="5846760"/>
            <a:ext cx="46872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Wnt-7a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3085920" y="5846760"/>
            <a:ext cx="15624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14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2786040" y="6048360"/>
            <a:ext cx="147132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Hippocampal neurons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3553920" y="5846760"/>
            <a:ext cx="52344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21 (DIV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703800" y="4591080"/>
            <a:ext cx="19584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0.4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703800" y="4309920"/>
            <a:ext cx="19584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0.5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703800" y="4873680"/>
            <a:ext cx="19584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0.3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703800" y="5156280"/>
            <a:ext cx="19584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0.2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9" name=""/>
          <p:cNvGrpSpPr/>
          <p:nvPr/>
        </p:nvGrpSpPr>
        <p:grpSpPr>
          <a:xfrm>
            <a:off x="1295280" y="5122800"/>
            <a:ext cx="63720" cy="63720"/>
            <a:chOff x="1295280" y="5122800"/>
            <a:chExt cx="63720" cy="63720"/>
          </a:xfrm>
        </p:grpSpPr>
        <p:sp>
          <p:nvSpPr>
            <p:cNvPr id="80" name=""/>
            <p:cNvSpPr/>
            <p:nvPr/>
          </p:nvSpPr>
          <p:spPr>
            <a:xfrm>
              <a:off x="1295280" y="5122800"/>
              <a:ext cx="63720" cy="63720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" bIns="-1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1295280" y="5122800"/>
              <a:ext cx="63720" cy="63720"/>
            </a:xfrm>
            <a:prstGeom prst="ellipse">
              <a:avLst/>
            </a:prstGeom>
            <a:noFill/>
            <a:ln cap="rnd"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" bIns="-1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2" name=""/>
          <p:cNvGrpSpPr/>
          <p:nvPr/>
        </p:nvGrpSpPr>
        <p:grpSpPr>
          <a:xfrm>
            <a:off x="1295280" y="5249880"/>
            <a:ext cx="63720" cy="63360"/>
            <a:chOff x="1295280" y="5249880"/>
            <a:chExt cx="63720" cy="63360"/>
          </a:xfrm>
        </p:grpSpPr>
        <p:sp>
          <p:nvSpPr>
            <p:cNvPr id="83" name=""/>
            <p:cNvSpPr/>
            <p:nvPr/>
          </p:nvSpPr>
          <p:spPr>
            <a:xfrm>
              <a:off x="1295280" y="5249880"/>
              <a:ext cx="63720" cy="63360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" bIns="-1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1295280" y="5249880"/>
              <a:ext cx="63720" cy="63360"/>
            </a:xfrm>
            <a:prstGeom prst="ellipse">
              <a:avLst/>
            </a:prstGeom>
            <a:noFill/>
            <a:ln cap="rnd"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" bIns="-1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5" name=""/>
          <p:cNvGrpSpPr/>
          <p:nvPr/>
        </p:nvGrpSpPr>
        <p:grpSpPr>
          <a:xfrm>
            <a:off x="1295280" y="5207040"/>
            <a:ext cx="63720" cy="63360"/>
            <a:chOff x="1295280" y="5207040"/>
            <a:chExt cx="63720" cy="63360"/>
          </a:xfrm>
        </p:grpSpPr>
        <p:sp>
          <p:nvSpPr>
            <p:cNvPr id="86" name=""/>
            <p:cNvSpPr/>
            <p:nvPr/>
          </p:nvSpPr>
          <p:spPr>
            <a:xfrm>
              <a:off x="1295280" y="5207040"/>
              <a:ext cx="63720" cy="63360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" bIns="-1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1295280" y="5207040"/>
              <a:ext cx="63720" cy="63360"/>
            </a:xfrm>
            <a:prstGeom prst="ellipse">
              <a:avLst/>
            </a:prstGeom>
            <a:noFill/>
            <a:ln cap="rnd"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" bIns="-1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8" name=""/>
          <p:cNvGrpSpPr/>
          <p:nvPr/>
        </p:nvGrpSpPr>
        <p:grpSpPr>
          <a:xfrm>
            <a:off x="1295280" y="5334120"/>
            <a:ext cx="63720" cy="63360"/>
            <a:chOff x="1295280" y="5334120"/>
            <a:chExt cx="63720" cy="63360"/>
          </a:xfrm>
        </p:grpSpPr>
        <p:sp>
          <p:nvSpPr>
            <p:cNvPr id="89" name=""/>
            <p:cNvSpPr/>
            <p:nvPr/>
          </p:nvSpPr>
          <p:spPr>
            <a:xfrm>
              <a:off x="1295280" y="5334120"/>
              <a:ext cx="63720" cy="63360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" bIns="-1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>
              <a:off x="1295280" y="5334120"/>
              <a:ext cx="63720" cy="63360"/>
            </a:xfrm>
            <a:prstGeom prst="ellipse">
              <a:avLst/>
            </a:prstGeom>
            <a:noFill/>
            <a:ln cap="rnd"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" bIns="-1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91" name=""/>
          <p:cNvGrpSpPr/>
          <p:nvPr/>
        </p:nvGrpSpPr>
        <p:grpSpPr>
          <a:xfrm>
            <a:off x="1930320" y="4697280"/>
            <a:ext cx="63720" cy="64800"/>
            <a:chOff x="1930320" y="4697280"/>
            <a:chExt cx="63720" cy="64800"/>
          </a:xfrm>
        </p:grpSpPr>
        <p:sp>
          <p:nvSpPr>
            <p:cNvPr id="92" name=""/>
            <p:cNvSpPr/>
            <p:nvPr/>
          </p:nvSpPr>
          <p:spPr>
            <a:xfrm>
              <a:off x="1930320" y="4697280"/>
              <a:ext cx="63720" cy="6480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" bIns="-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"/>
            <p:cNvSpPr/>
            <p:nvPr/>
          </p:nvSpPr>
          <p:spPr>
            <a:xfrm>
              <a:off x="1930320" y="4697280"/>
              <a:ext cx="63720" cy="64800"/>
            </a:xfrm>
            <a:prstGeom prst="ellipse">
              <a:avLst/>
            </a:prstGeom>
            <a:noFill/>
            <a:ln cap="rnd"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" bIns="-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94" name=""/>
          <p:cNvGrpSpPr/>
          <p:nvPr/>
        </p:nvGrpSpPr>
        <p:grpSpPr>
          <a:xfrm>
            <a:off x="1930320" y="4826160"/>
            <a:ext cx="63720" cy="63360"/>
            <a:chOff x="1930320" y="4826160"/>
            <a:chExt cx="63720" cy="63360"/>
          </a:xfrm>
        </p:grpSpPr>
        <p:sp>
          <p:nvSpPr>
            <p:cNvPr id="95" name=""/>
            <p:cNvSpPr/>
            <p:nvPr/>
          </p:nvSpPr>
          <p:spPr>
            <a:xfrm>
              <a:off x="1930320" y="4826160"/>
              <a:ext cx="63720" cy="6336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" bIns="-1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"/>
            <p:cNvSpPr/>
            <p:nvPr/>
          </p:nvSpPr>
          <p:spPr>
            <a:xfrm>
              <a:off x="1930320" y="4826160"/>
              <a:ext cx="63720" cy="63360"/>
            </a:xfrm>
            <a:prstGeom prst="ellipse">
              <a:avLst/>
            </a:prstGeom>
            <a:noFill/>
            <a:ln cap="rnd"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" bIns="-1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97" name=""/>
          <p:cNvGrpSpPr/>
          <p:nvPr/>
        </p:nvGrpSpPr>
        <p:grpSpPr>
          <a:xfrm>
            <a:off x="1930320" y="4782960"/>
            <a:ext cx="63720" cy="63360"/>
            <a:chOff x="1930320" y="4782960"/>
            <a:chExt cx="63720" cy="63360"/>
          </a:xfrm>
        </p:grpSpPr>
        <p:sp>
          <p:nvSpPr>
            <p:cNvPr id="98" name=""/>
            <p:cNvSpPr/>
            <p:nvPr/>
          </p:nvSpPr>
          <p:spPr>
            <a:xfrm>
              <a:off x="1930320" y="4782960"/>
              <a:ext cx="63720" cy="6336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" bIns="-1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"/>
            <p:cNvSpPr/>
            <p:nvPr/>
          </p:nvSpPr>
          <p:spPr>
            <a:xfrm>
              <a:off x="1930320" y="4782960"/>
              <a:ext cx="63720" cy="63360"/>
            </a:xfrm>
            <a:prstGeom prst="ellipse">
              <a:avLst/>
            </a:prstGeom>
            <a:noFill/>
            <a:ln cap="rnd"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" bIns="-1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00" name=""/>
          <p:cNvGrpSpPr/>
          <p:nvPr/>
        </p:nvGrpSpPr>
        <p:grpSpPr>
          <a:xfrm>
            <a:off x="1930320" y="4910040"/>
            <a:ext cx="63720" cy="63360"/>
            <a:chOff x="1930320" y="4910040"/>
            <a:chExt cx="63720" cy="63360"/>
          </a:xfrm>
        </p:grpSpPr>
        <p:sp>
          <p:nvSpPr>
            <p:cNvPr id="101" name=""/>
            <p:cNvSpPr/>
            <p:nvPr/>
          </p:nvSpPr>
          <p:spPr>
            <a:xfrm>
              <a:off x="1930320" y="4910040"/>
              <a:ext cx="63720" cy="6336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" bIns="-1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"/>
            <p:cNvSpPr/>
            <p:nvPr/>
          </p:nvSpPr>
          <p:spPr>
            <a:xfrm>
              <a:off x="1930320" y="4910040"/>
              <a:ext cx="63720" cy="63360"/>
            </a:xfrm>
            <a:prstGeom prst="ellipse">
              <a:avLst/>
            </a:prstGeom>
            <a:noFill/>
            <a:ln cap="rnd"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" bIns="-1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03" name=""/>
          <p:cNvGrpSpPr/>
          <p:nvPr/>
        </p:nvGrpSpPr>
        <p:grpSpPr>
          <a:xfrm>
            <a:off x="2397240" y="5386320"/>
            <a:ext cx="63360" cy="63360"/>
            <a:chOff x="2397240" y="5386320"/>
            <a:chExt cx="63360" cy="63360"/>
          </a:xfrm>
        </p:grpSpPr>
        <p:sp>
          <p:nvSpPr>
            <p:cNvPr id="104" name=""/>
            <p:cNvSpPr/>
            <p:nvPr/>
          </p:nvSpPr>
          <p:spPr>
            <a:xfrm>
              <a:off x="2397240" y="5386320"/>
              <a:ext cx="63360" cy="63360"/>
            </a:xfrm>
            <a:prstGeom prst="ellipse">
              <a:avLst/>
            </a:prstGeom>
            <a:solidFill>
              <a:srgbClr val="80808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" bIns="-1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"/>
            <p:cNvSpPr/>
            <p:nvPr/>
          </p:nvSpPr>
          <p:spPr>
            <a:xfrm>
              <a:off x="2397240" y="5386320"/>
              <a:ext cx="63360" cy="63360"/>
            </a:xfrm>
            <a:prstGeom prst="ellipse">
              <a:avLst/>
            </a:prstGeom>
            <a:noFill/>
            <a:ln cap="rnd"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" bIns="-1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06" name=""/>
          <p:cNvGrpSpPr/>
          <p:nvPr/>
        </p:nvGrpSpPr>
        <p:grpSpPr>
          <a:xfrm>
            <a:off x="2397240" y="5334120"/>
            <a:ext cx="63360" cy="63360"/>
            <a:chOff x="2397240" y="5334120"/>
            <a:chExt cx="63360" cy="63360"/>
          </a:xfrm>
        </p:grpSpPr>
        <p:sp>
          <p:nvSpPr>
            <p:cNvPr id="107" name=""/>
            <p:cNvSpPr/>
            <p:nvPr/>
          </p:nvSpPr>
          <p:spPr>
            <a:xfrm>
              <a:off x="2397240" y="5334120"/>
              <a:ext cx="63360" cy="63360"/>
            </a:xfrm>
            <a:prstGeom prst="ellipse">
              <a:avLst/>
            </a:prstGeom>
            <a:solidFill>
              <a:srgbClr val="80808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" bIns="-1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"/>
            <p:cNvSpPr/>
            <p:nvPr/>
          </p:nvSpPr>
          <p:spPr>
            <a:xfrm>
              <a:off x="2397240" y="5334120"/>
              <a:ext cx="63360" cy="63360"/>
            </a:xfrm>
            <a:prstGeom prst="ellipse">
              <a:avLst/>
            </a:prstGeom>
            <a:noFill/>
            <a:ln cap="rnd"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" bIns="-1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09" name=""/>
          <p:cNvGrpSpPr/>
          <p:nvPr/>
        </p:nvGrpSpPr>
        <p:grpSpPr>
          <a:xfrm>
            <a:off x="2397240" y="5460840"/>
            <a:ext cx="63360" cy="63360"/>
            <a:chOff x="2397240" y="5460840"/>
            <a:chExt cx="63360" cy="63360"/>
          </a:xfrm>
        </p:grpSpPr>
        <p:sp>
          <p:nvSpPr>
            <p:cNvPr id="110" name=""/>
            <p:cNvSpPr/>
            <p:nvPr/>
          </p:nvSpPr>
          <p:spPr>
            <a:xfrm>
              <a:off x="2397240" y="5460840"/>
              <a:ext cx="63360" cy="63360"/>
            </a:xfrm>
            <a:prstGeom prst="ellipse">
              <a:avLst/>
            </a:prstGeom>
            <a:solidFill>
              <a:srgbClr val="80808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" bIns="-1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"/>
            <p:cNvSpPr/>
            <p:nvPr/>
          </p:nvSpPr>
          <p:spPr>
            <a:xfrm>
              <a:off x="2397240" y="5460840"/>
              <a:ext cx="63360" cy="63360"/>
            </a:xfrm>
            <a:prstGeom prst="ellipse">
              <a:avLst/>
            </a:prstGeom>
            <a:noFill/>
            <a:ln cap="rnd"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" bIns="-1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12" name=""/>
          <p:cNvSpPr/>
          <p:nvPr/>
        </p:nvSpPr>
        <p:spPr>
          <a:xfrm>
            <a:off x="952560" y="5326200"/>
            <a:ext cx="3101760" cy="6120"/>
          </a:xfrm>
          <a:custGeom>
            <a:avLst/>
            <a:gdLst/>
            <a:ahLst/>
            <a:rect l="l" t="t" r="r" b="b"/>
            <a:pathLst>
              <a:path w="13825" h="25">
                <a:moveTo>
                  <a:pt x="13" y="0"/>
                </a:moveTo>
                <a:lnTo>
                  <a:pt x="188" y="0"/>
                </a:lnTo>
                <a:cubicBezTo>
                  <a:pt x="195" y="0"/>
                  <a:pt x="200" y="6"/>
                  <a:pt x="200" y="13"/>
                </a:cubicBezTo>
                <a:cubicBezTo>
                  <a:pt x="200" y="20"/>
                  <a:pt x="195" y="25"/>
                  <a:pt x="188" y="25"/>
                </a:cubicBezTo>
                <a:lnTo>
                  <a:pt x="13" y="25"/>
                </a:lnTo>
                <a:cubicBezTo>
                  <a:pt x="6" y="25"/>
                  <a:pt x="0" y="20"/>
                  <a:pt x="0" y="13"/>
                </a:cubicBezTo>
                <a:cubicBezTo>
                  <a:pt x="0" y="6"/>
                  <a:pt x="6" y="0"/>
                  <a:pt x="13" y="0"/>
                </a:cubicBezTo>
                <a:close/>
                <a:moveTo>
                  <a:pt x="288" y="0"/>
                </a:moveTo>
                <a:lnTo>
                  <a:pt x="463" y="0"/>
                </a:lnTo>
                <a:cubicBezTo>
                  <a:pt x="470" y="0"/>
                  <a:pt x="475" y="6"/>
                  <a:pt x="475" y="13"/>
                </a:cubicBezTo>
                <a:cubicBezTo>
                  <a:pt x="475" y="20"/>
                  <a:pt x="470" y="25"/>
                  <a:pt x="463" y="25"/>
                </a:cubicBezTo>
                <a:lnTo>
                  <a:pt x="288" y="25"/>
                </a:lnTo>
                <a:cubicBezTo>
                  <a:pt x="281" y="25"/>
                  <a:pt x="275" y="20"/>
                  <a:pt x="275" y="13"/>
                </a:cubicBezTo>
                <a:cubicBezTo>
                  <a:pt x="275" y="6"/>
                  <a:pt x="281" y="0"/>
                  <a:pt x="288" y="0"/>
                </a:cubicBezTo>
                <a:close/>
                <a:moveTo>
                  <a:pt x="563" y="0"/>
                </a:moveTo>
                <a:lnTo>
                  <a:pt x="738" y="0"/>
                </a:lnTo>
                <a:cubicBezTo>
                  <a:pt x="745" y="0"/>
                  <a:pt x="750" y="6"/>
                  <a:pt x="750" y="13"/>
                </a:cubicBezTo>
                <a:cubicBezTo>
                  <a:pt x="750" y="20"/>
                  <a:pt x="745" y="25"/>
                  <a:pt x="738" y="25"/>
                </a:cubicBezTo>
                <a:lnTo>
                  <a:pt x="563" y="25"/>
                </a:lnTo>
                <a:cubicBezTo>
                  <a:pt x="556" y="25"/>
                  <a:pt x="550" y="20"/>
                  <a:pt x="550" y="13"/>
                </a:cubicBezTo>
                <a:cubicBezTo>
                  <a:pt x="550" y="6"/>
                  <a:pt x="556" y="0"/>
                  <a:pt x="563" y="0"/>
                </a:cubicBezTo>
                <a:close/>
                <a:moveTo>
                  <a:pt x="838" y="0"/>
                </a:moveTo>
                <a:lnTo>
                  <a:pt x="1013" y="0"/>
                </a:lnTo>
                <a:cubicBezTo>
                  <a:pt x="1020" y="0"/>
                  <a:pt x="1025" y="6"/>
                  <a:pt x="1025" y="13"/>
                </a:cubicBezTo>
                <a:cubicBezTo>
                  <a:pt x="1025" y="20"/>
                  <a:pt x="1020" y="25"/>
                  <a:pt x="1013" y="25"/>
                </a:cubicBezTo>
                <a:lnTo>
                  <a:pt x="838" y="25"/>
                </a:lnTo>
                <a:cubicBezTo>
                  <a:pt x="831" y="25"/>
                  <a:pt x="825" y="20"/>
                  <a:pt x="825" y="13"/>
                </a:cubicBezTo>
                <a:cubicBezTo>
                  <a:pt x="825" y="6"/>
                  <a:pt x="831" y="0"/>
                  <a:pt x="838" y="0"/>
                </a:cubicBezTo>
                <a:close/>
                <a:moveTo>
                  <a:pt x="1113" y="0"/>
                </a:moveTo>
                <a:lnTo>
                  <a:pt x="1288" y="0"/>
                </a:lnTo>
                <a:cubicBezTo>
                  <a:pt x="1295" y="0"/>
                  <a:pt x="1300" y="6"/>
                  <a:pt x="1300" y="13"/>
                </a:cubicBezTo>
                <a:cubicBezTo>
                  <a:pt x="1300" y="20"/>
                  <a:pt x="1295" y="25"/>
                  <a:pt x="1288" y="25"/>
                </a:cubicBezTo>
                <a:lnTo>
                  <a:pt x="1113" y="25"/>
                </a:lnTo>
                <a:cubicBezTo>
                  <a:pt x="1106" y="25"/>
                  <a:pt x="1100" y="20"/>
                  <a:pt x="1100" y="13"/>
                </a:cubicBezTo>
                <a:cubicBezTo>
                  <a:pt x="1100" y="6"/>
                  <a:pt x="1106" y="0"/>
                  <a:pt x="1113" y="0"/>
                </a:cubicBezTo>
                <a:close/>
                <a:moveTo>
                  <a:pt x="1388" y="0"/>
                </a:moveTo>
                <a:lnTo>
                  <a:pt x="1563" y="0"/>
                </a:lnTo>
                <a:cubicBezTo>
                  <a:pt x="1570" y="0"/>
                  <a:pt x="1575" y="6"/>
                  <a:pt x="1575" y="13"/>
                </a:cubicBezTo>
                <a:cubicBezTo>
                  <a:pt x="1575" y="20"/>
                  <a:pt x="1570" y="25"/>
                  <a:pt x="1563" y="25"/>
                </a:cubicBezTo>
                <a:lnTo>
                  <a:pt x="1388" y="25"/>
                </a:lnTo>
                <a:cubicBezTo>
                  <a:pt x="1381" y="25"/>
                  <a:pt x="1375" y="20"/>
                  <a:pt x="1375" y="13"/>
                </a:cubicBezTo>
                <a:cubicBezTo>
                  <a:pt x="1375" y="6"/>
                  <a:pt x="1381" y="0"/>
                  <a:pt x="1388" y="0"/>
                </a:cubicBezTo>
                <a:close/>
                <a:moveTo>
                  <a:pt x="1663" y="0"/>
                </a:moveTo>
                <a:lnTo>
                  <a:pt x="1838" y="0"/>
                </a:lnTo>
                <a:cubicBezTo>
                  <a:pt x="1845" y="0"/>
                  <a:pt x="1850" y="6"/>
                  <a:pt x="1850" y="13"/>
                </a:cubicBezTo>
                <a:cubicBezTo>
                  <a:pt x="1850" y="20"/>
                  <a:pt x="1845" y="25"/>
                  <a:pt x="1838" y="25"/>
                </a:cubicBezTo>
                <a:lnTo>
                  <a:pt x="1663" y="25"/>
                </a:lnTo>
                <a:cubicBezTo>
                  <a:pt x="1656" y="25"/>
                  <a:pt x="1650" y="20"/>
                  <a:pt x="1650" y="13"/>
                </a:cubicBezTo>
                <a:cubicBezTo>
                  <a:pt x="1650" y="6"/>
                  <a:pt x="1656" y="0"/>
                  <a:pt x="1663" y="0"/>
                </a:cubicBezTo>
                <a:close/>
                <a:moveTo>
                  <a:pt x="1938" y="0"/>
                </a:moveTo>
                <a:lnTo>
                  <a:pt x="2113" y="0"/>
                </a:lnTo>
                <a:cubicBezTo>
                  <a:pt x="2120" y="0"/>
                  <a:pt x="2125" y="6"/>
                  <a:pt x="2125" y="13"/>
                </a:cubicBezTo>
                <a:cubicBezTo>
                  <a:pt x="2125" y="20"/>
                  <a:pt x="2120" y="25"/>
                  <a:pt x="2113" y="25"/>
                </a:cubicBezTo>
                <a:lnTo>
                  <a:pt x="1938" y="25"/>
                </a:lnTo>
                <a:cubicBezTo>
                  <a:pt x="1931" y="25"/>
                  <a:pt x="1925" y="20"/>
                  <a:pt x="1925" y="13"/>
                </a:cubicBezTo>
                <a:cubicBezTo>
                  <a:pt x="1925" y="6"/>
                  <a:pt x="1931" y="0"/>
                  <a:pt x="1938" y="0"/>
                </a:cubicBezTo>
                <a:close/>
                <a:moveTo>
                  <a:pt x="2213" y="0"/>
                </a:moveTo>
                <a:lnTo>
                  <a:pt x="2388" y="0"/>
                </a:lnTo>
                <a:cubicBezTo>
                  <a:pt x="2395" y="0"/>
                  <a:pt x="2400" y="6"/>
                  <a:pt x="2400" y="13"/>
                </a:cubicBezTo>
                <a:cubicBezTo>
                  <a:pt x="2400" y="20"/>
                  <a:pt x="2395" y="25"/>
                  <a:pt x="2388" y="25"/>
                </a:cubicBezTo>
                <a:lnTo>
                  <a:pt x="2213" y="25"/>
                </a:lnTo>
                <a:cubicBezTo>
                  <a:pt x="2206" y="25"/>
                  <a:pt x="2200" y="20"/>
                  <a:pt x="2200" y="13"/>
                </a:cubicBezTo>
                <a:cubicBezTo>
                  <a:pt x="2200" y="6"/>
                  <a:pt x="2206" y="0"/>
                  <a:pt x="2213" y="0"/>
                </a:cubicBezTo>
                <a:close/>
                <a:moveTo>
                  <a:pt x="2488" y="0"/>
                </a:moveTo>
                <a:lnTo>
                  <a:pt x="2663" y="0"/>
                </a:lnTo>
                <a:cubicBezTo>
                  <a:pt x="2670" y="0"/>
                  <a:pt x="2675" y="6"/>
                  <a:pt x="2675" y="13"/>
                </a:cubicBezTo>
                <a:cubicBezTo>
                  <a:pt x="2675" y="20"/>
                  <a:pt x="2670" y="25"/>
                  <a:pt x="2663" y="25"/>
                </a:cubicBezTo>
                <a:lnTo>
                  <a:pt x="2488" y="25"/>
                </a:lnTo>
                <a:cubicBezTo>
                  <a:pt x="2481" y="25"/>
                  <a:pt x="2475" y="20"/>
                  <a:pt x="2475" y="13"/>
                </a:cubicBezTo>
                <a:cubicBezTo>
                  <a:pt x="2475" y="6"/>
                  <a:pt x="2481" y="0"/>
                  <a:pt x="2488" y="0"/>
                </a:cubicBezTo>
                <a:close/>
                <a:moveTo>
                  <a:pt x="2763" y="0"/>
                </a:moveTo>
                <a:lnTo>
                  <a:pt x="2938" y="0"/>
                </a:lnTo>
                <a:cubicBezTo>
                  <a:pt x="2945" y="0"/>
                  <a:pt x="2950" y="6"/>
                  <a:pt x="2950" y="13"/>
                </a:cubicBezTo>
                <a:cubicBezTo>
                  <a:pt x="2950" y="20"/>
                  <a:pt x="2945" y="25"/>
                  <a:pt x="2938" y="25"/>
                </a:cubicBezTo>
                <a:lnTo>
                  <a:pt x="2763" y="25"/>
                </a:lnTo>
                <a:cubicBezTo>
                  <a:pt x="2756" y="25"/>
                  <a:pt x="2750" y="20"/>
                  <a:pt x="2750" y="13"/>
                </a:cubicBezTo>
                <a:cubicBezTo>
                  <a:pt x="2750" y="6"/>
                  <a:pt x="2756" y="0"/>
                  <a:pt x="2763" y="0"/>
                </a:cubicBezTo>
                <a:close/>
                <a:moveTo>
                  <a:pt x="3038" y="0"/>
                </a:moveTo>
                <a:lnTo>
                  <a:pt x="3213" y="0"/>
                </a:lnTo>
                <a:cubicBezTo>
                  <a:pt x="3220" y="0"/>
                  <a:pt x="3225" y="6"/>
                  <a:pt x="3225" y="13"/>
                </a:cubicBezTo>
                <a:cubicBezTo>
                  <a:pt x="3225" y="20"/>
                  <a:pt x="3220" y="25"/>
                  <a:pt x="3213" y="25"/>
                </a:cubicBezTo>
                <a:lnTo>
                  <a:pt x="3038" y="25"/>
                </a:lnTo>
                <a:cubicBezTo>
                  <a:pt x="3031" y="25"/>
                  <a:pt x="3025" y="20"/>
                  <a:pt x="3025" y="13"/>
                </a:cubicBezTo>
                <a:cubicBezTo>
                  <a:pt x="3025" y="6"/>
                  <a:pt x="3031" y="0"/>
                  <a:pt x="3038" y="0"/>
                </a:cubicBezTo>
                <a:close/>
                <a:moveTo>
                  <a:pt x="3313" y="0"/>
                </a:moveTo>
                <a:lnTo>
                  <a:pt x="3488" y="0"/>
                </a:lnTo>
                <a:cubicBezTo>
                  <a:pt x="3495" y="0"/>
                  <a:pt x="3500" y="6"/>
                  <a:pt x="3500" y="13"/>
                </a:cubicBezTo>
                <a:cubicBezTo>
                  <a:pt x="3500" y="20"/>
                  <a:pt x="3495" y="25"/>
                  <a:pt x="3488" y="25"/>
                </a:cubicBezTo>
                <a:lnTo>
                  <a:pt x="3313" y="25"/>
                </a:lnTo>
                <a:cubicBezTo>
                  <a:pt x="3306" y="25"/>
                  <a:pt x="3300" y="20"/>
                  <a:pt x="3300" y="13"/>
                </a:cubicBezTo>
                <a:cubicBezTo>
                  <a:pt x="3300" y="6"/>
                  <a:pt x="3306" y="0"/>
                  <a:pt x="3313" y="0"/>
                </a:cubicBezTo>
                <a:close/>
                <a:moveTo>
                  <a:pt x="3588" y="0"/>
                </a:moveTo>
                <a:lnTo>
                  <a:pt x="3763" y="0"/>
                </a:lnTo>
                <a:cubicBezTo>
                  <a:pt x="3770" y="0"/>
                  <a:pt x="3775" y="6"/>
                  <a:pt x="3775" y="13"/>
                </a:cubicBezTo>
                <a:cubicBezTo>
                  <a:pt x="3775" y="20"/>
                  <a:pt x="3770" y="25"/>
                  <a:pt x="3763" y="25"/>
                </a:cubicBezTo>
                <a:lnTo>
                  <a:pt x="3588" y="25"/>
                </a:lnTo>
                <a:cubicBezTo>
                  <a:pt x="3581" y="25"/>
                  <a:pt x="3575" y="20"/>
                  <a:pt x="3575" y="13"/>
                </a:cubicBezTo>
                <a:cubicBezTo>
                  <a:pt x="3575" y="6"/>
                  <a:pt x="3581" y="0"/>
                  <a:pt x="3588" y="0"/>
                </a:cubicBezTo>
                <a:close/>
                <a:moveTo>
                  <a:pt x="3863" y="0"/>
                </a:moveTo>
                <a:lnTo>
                  <a:pt x="4038" y="0"/>
                </a:lnTo>
                <a:cubicBezTo>
                  <a:pt x="4045" y="0"/>
                  <a:pt x="4050" y="6"/>
                  <a:pt x="4050" y="13"/>
                </a:cubicBezTo>
                <a:cubicBezTo>
                  <a:pt x="4050" y="20"/>
                  <a:pt x="4045" y="25"/>
                  <a:pt x="4038" y="25"/>
                </a:cubicBezTo>
                <a:lnTo>
                  <a:pt x="3863" y="25"/>
                </a:lnTo>
                <a:cubicBezTo>
                  <a:pt x="3856" y="25"/>
                  <a:pt x="3850" y="20"/>
                  <a:pt x="3850" y="13"/>
                </a:cubicBezTo>
                <a:cubicBezTo>
                  <a:pt x="3850" y="6"/>
                  <a:pt x="3856" y="0"/>
                  <a:pt x="3863" y="0"/>
                </a:cubicBezTo>
                <a:close/>
                <a:moveTo>
                  <a:pt x="4138" y="0"/>
                </a:moveTo>
                <a:lnTo>
                  <a:pt x="4313" y="0"/>
                </a:lnTo>
                <a:cubicBezTo>
                  <a:pt x="4320" y="0"/>
                  <a:pt x="4325" y="6"/>
                  <a:pt x="4325" y="13"/>
                </a:cubicBezTo>
                <a:cubicBezTo>
                  <a:pt x="4325" y="20"/>
                  <a:pt x="4320" y="25"/>
                  <a:pt x="4313" y="25"/>
                </a:cubicBezTo>
                <a:lnTo>
                  <a:pt x="4138" y="25"/>
                </a:lnTo>
                <a:cubicBezTo>
                  <a:pt x="4131" y="25"/>
                  <a:pt x="4125" y="20"/>
                  <a:pt x="4125" y="13"/>
                </a:cubicBezTo>
                <a:cubicBezTo>
                  <a:pt x="4125" y="6"/>
                  <a:pt x="4131" y="0"/>
                  <a:pt x="4138" y="0"/>
                </a:cubicBezTo>
                <a:close/>
                <a:moveTo>
                  <a:pt x="4413" y="0"/>
                </a:moveTo>
                <a:lnTo>
                  <a:pt x="4588" y="0"/>
                </a:lnTo>
                <a:cubicBezTo>
                  <a:pt x="4595" y="0"/>
                  <a:pt x="4600" y="6"/>
                  <a:pt x="4600" y="13"/>
                </a:cubicBezTo>
                <a:cubicBezTo>
                  <a:pt x="4600" y="20"/>
                  <a:pt x="4595" y="25"/>
                  <a:pt x="4588" y="25"/>
                </a:cubicBezTo>
                <a:lnTo>
                  <a:pt x="4413" y="25"/>
                </a:lnTo>
                <a:cubicBezTo>
                  <a:pt x="4406" y="25"/>
                  <a:pt x="4400" y="20"/>
                  <a:pt x="4400" y="13"/>
                </a:cubicBezTo>
                <a:cubicBezTo>
                  <a:pt x="4400" y="6"/>
                  <a:pt x="4406" y="0"/>
                  <a:pt x="4413" y="0"/>
                </a:cubicBezTo>
                <a:close/>
                <a:moveTo>
                  <a:pt x="4688" y="0"/>
                </a:moveTo>
                <a:lnTo>
                  <a:pt x="4863" y="0"/>
                </a:lnTo>
                <a:cubicBezTo>
                  <a:pt x="4870" y="0"/>
                  <a:pt x="4875" y="6"/>
                  <a:pt x="4875" y="13"/>
                </a:cubicBezTo>
                <a:cubicBezTo>
                  <a:pt x="4875" y="20"/>
                  <a:pt x="4870" y="25"/>
                  <a:pt x="4863" y="25"/>
                </a:cubicBezTo>
                <a:lnTo>
                  <a:pt x="4688" y="25"/>
                </a:lnTo>
                <a:cubicBezTo>
                  <a:pt x="4681" y="25"/>
                  <a:pt x="4675" y="20"/>
                  <a:pt x="4675" y="13"/>
                </a:cubicBezTo>
                <a:cubicBezTo>
                  <a:pt x="4675" y="6"/>
                  <a:pt x="4681" y="0"/>
                  <a:pt x="4688" y="0"/>
                </a:cubicBezTo>
                <a:close/>
                <a:moveTo>
                  <a:pt x="4963" y="0"/>
                </a:moveTo>
                <a:lnTo>
                  <a:pt x="5138" y="0"/>
                </a:lnTo>
                <a:cubicBezTo>
                  <a:pt x="5145" y="0"/>
                  <a:pt x="5150" y="6"/>
                  <a:pt x="5150" y="13"/>
                </a:cubicBezTo>
                <a:cubicBezTo>
                  <a:pt x="5150" y="20"/>
                  <a:pt x="5145" y="25"/>
                  <a:pt x="5138" y="25"/>
                </a:cubicBezTo>
                <a:lnTo>
                  <a:pt x="4963" y="25"/>
                </a:lnTo>
                <a:cubicBezTo>
                  <a:pt x="4956" y="25"/>
                  <a:pt x="4950" y="20"/>
                  <a:pt x="4950" y="13"/>
                </a:cubicBezTo>
                <a:cubicBezTo>
                  <a:pt x="4950" y="6"/>
                  <a:pt x="4956" y="0"/>
                  <a:pt x="4963" y="0"/>
                </a:cubicBezTo>
                <a:close/>
                <a:moveTo>
                  <a:pt x="5238" y="0"/>
                </a:moveTo>
                <a:lnTo>
                  <a:pt x="5413" y="0"/>
                </a:lnTo>
                <a:cubicBezTo>
                  <a:pt x="5420" y="0"/>
                  <a:pt x="5425" y="6"/>
                  <a:pt x="5425" y="13"/>
                </a:cubicBezTo>
                <a:cubicBezTo>
                  <a:pt x="5425" y="20"/>
                  <a:pt x="5420" y="25"/>
                  <a:pt x="5413" y="25"/>
                </a:cubicBezTo>
                <a:lnTo>
                  <a:pt x="5238" y="25"/>
                </a:lnTo>
                <a:cubicBezTo>
                  <a:pt x="5231" y="25"/>
                  <a:pt x="5225" y="20"/>
                  <a:pt x="5225" y="13"/>
                </a:cubicBezTo>
                <a:cubicBezTo>
                  <a:pt x="5225" y="6"/>
                  <a:pt x="5231" y="0"/>
                  <a:pt x="5238" y="0"/>
                </a:cubicBezTo>
                <a:close/>
                <a:moveTo>
                  <a:pt x="5513" y="0"/>
                </a:moveTo>
                <a:lnTo>
                  <a:pt x="5688" y="0"/>
                </a:lnTo>
                <a:cubicBezTo>
                  <a:pt x="5695" y="0"/>
                  <a:pt x="5700" y="6"/>
                  <a:pt x="5700" y="13"/>
                </a:cubicBezTo>
                <a:cubicBezTo>
                  <a:pt x="5700" y="20"/>
                  <a:pt x="5695" y="25"/>
                  <a:pt x="5688" y="25"/>
                </a:cubicBezTo>
                <a:lnTo>
                  <a:pt x="5513" y="25"/>
                </a:lnTo>
                <a:cubicBezTo>
                  <a:pt x="5506" y="25"/>
                  <a:pt x="5500" y="20"/>
                  <a:pt x="5500" y="13"/>
                </a:cubicBezTo>
                <a:cubicBezTo>
                  <a:pt x="5500" y="6"/>
                  <a:pt x="5506" y="0"/>
                  <a:pt x="5513" y="0"/>
                </a:cubicBezTo>
                <a:close/>
                <a:moveTo>
                  <a:pt x="5788" y="0"/>
                </a:moveTo>
                <a:lnTo>
                  <a:pt x="5963" y="0"/>
                </a:lnTo>
                <a:cubicBezTo>
                  <a:pt x="5970" y="0"/>
                  <a:pt x="5975" y="6"/>
                  <a:pt x="5975" y="13"/>
                </a:cubicBezTo>
                <a:cubicBezTo>
                  <a:pt x="5975" y="20"/>
                  <a:pt x="5970" y="25"/>
                  <a:pt x="5963" y="25"/>
                </a:cubicBezTo>
                <a:lnTo>
                  <a:pt x="5788" y="25"/>
                </a:lnTo>
                <a:cubicBezTo>
                  <a:pt x="5781" y="25"/>
                  <a:pt x="5775" y="20"/>
                  <a:pt x="5775" y="13"/>
                </a:cubicBezTo>
                <a:cubicBezTo>
                  <a:pt x="5775" y="6"/>
                  <a:pt x="5781" y="0"/>
                  <a:pt x="5788" y="0"/>
                </a:cubicBezTo>
                <a:close/>
                <a:moveTo>
                  <a:pt x="6063" y="0"/>
                </a:moveTo>
                <a:lnTo>
                  <a:pt x="6238" y="0"/>
                </a:lnTo>
                <a:cubicBezTo>
                  <a:pt x="6245" y="0"/>
                  <a:pt x="6250" y="6"/>
                  <a:pt x="6250" y="13"/>
                </a:cubicBezTo>
                <a:cubicBezTo>
                  <a:pt x="6250" y="20"/>
                  <a:pt x="6245" y="25"/>
                  <a:pt x="6238" y="25"/>
                </a:cubicBezTo>
                <a:lnTo>
                  <a:pt x="6063" y="25"/>
                </a:lnTo>
                <a:cubicBezTo>
                  <a:pt x="6056" y="25"/>
                  <a:pt x="6050" y="20"/>
                  <a:pt x="6050" y="13"/>
                </a:cubicBezTo>
                <a:cubicBezTo>
                  <a:pt x="6050" y="6"/>
                  <a:pt x="6056" y="0"/>
                  <a:pt x="6063" y="0"/>
                </a:cubicBezTo>
                <a:close/>
                <a:moveTo>
                  <a:pt x="6338" y="0"/>
                </a:moveTo>
                <a:lnTo>
                  <a:pt x="6513" y="0"/>
                </a:lnTo>
                <a:cubicBezTo>
                  <a:pt x="6520" y="0"/>
                  <a:pt x="6525" y="6"/>
                  <a:pt x="6525" y="13"/>
                </a:cubicBezTo>
                <a:cubicBezTo>
                  <a:pt x="6525" y="20"/>
                  <a:pt x="6520" y="25"/>
                  <a:pt x="6513" y="25"/>
                </a:cubicBezTo>
                <a:lnTo>
                  <a:pt x="6338" y="25"/>
                </a:lnTo>
                <a:cubicBezTo>
                  <a:pt x="6331" y="25"/>
                  <a:pt x="6325" y="20"/>
                  <a:pt x="6325" y="13"/>
                </a:cubicBezTo>
                <a:cubicBezTo>
                  <a:pt x="6325" y="6"/>
                  <a:pt x="6331" y="0"/>
                  <a:pt x="6338" y="0"/>
                </a:cubicBezTo>
                <a:close/>
                <a:moveTo>
                  <a:pt x="6613" y="0"/>
                </a:moveTo>
                <a:lnTo>
                  <a:pt x="6788" y="0"/>
                </a:lnTo>
                <a:cubicBezTo>
                  <a:pt x="6795" y="0"/>
                  <a:pt x="6800" y="6"/>
                  <a:pt x="6800" y="13"/>
                </a:cubicBezTo>
                <a:cubicBezTo>
                  <a:pt x="6800" y="20"/>
                  <a:pt x="6795" y="25"/>
                  <a:pt x="6788" y="25"/>
                </a:cubicBezTo>
                <a:lnTo>
                  <a:pt x="6613" y="25"/>
                </a:lnTo>
                <a:cubicBezTo>
                  <a:pt x="6606" y="25"/>
                  <a:pt x="6600" y="20"/>
                  <a:pt x="6600" y="13"/>
                </a:cubicBezTo>
                <a:cubicBezTo>
                  <a:pt x="6600" y="6"/>
                  <a:pt x="6606" y="0"/>
                  <a:pt x="6613" y="0"/>
                </a:cubicBezTo>
                <a:close/>
                <a:moveTo>
                  <a:pt x="6888" y="0"/>
                </a:moveTo>
                <a:lnTo>
                  <a:pt x="7063" y="0"/>
                </a:lnTo>
                <a:cubicBezTo>
                  <a:pt x="7070" y="0"/>
                  <a:pt x="7075" y="6"/>
                  <a:pt x="7075" y="13"/>
                </a:cubicBezTo>
                <a:cubicBezTo>
                  <a:pt x="7075" y="20"/>
                  <a:pt x="7070" y="25"/>
                  <a:pt x="7063" y="25"/>
                </a:cubicBezTo>
                <a:lnTo>
                  <a:pt x="6888" y="25"/>
                </a:lnTo>
                <a:cubicBezTo>
                  <a:pt x="6881" y="25"/>
                  <a:pt x="6875" y="20"/>
                  <a:pt x="6875" y="13"/>
                </a:cubicBezTo>
                <a:cubicBezTo>
                  <a:pt x="6875" y="6"/>
                  <a:pt x="6881" y="0"/>
                  <a:pt x="6888" y="0"/>
                </a:cubicBezTo>
                <a:close/>
                <a:moveTo>
                  <a:pt x="7163" y="0"/>
                </a:moveTo>
                <a:lnTo>
                  <a:pt x="7338" y="0"/>
                </a:lnTo>
                <a:cubicBezTo>
                  <a:pt x="7345" y="0"/>
                  <a:pt x="7350" y="6"/>
                  <a:pt x="7350" y="13"/>
                </a:cubicBezTo>
                <a:cubicBezTo>
                  <a:pt x="7350" y="20"/>
                  <a:pt x="7345" y="25"/>
                  <a:pt x="7338" y="25"/>
                </a:cubicBezTo>
                <a:lnTo>
                  <a:pt x="7163" y="25"/>
                </a:lnTo>
                <a:cubicBezTo>
                  <a:pt x="7156" y="25"/>
                  <a:pt x="7150" y="20"/>
                  <a:pt x="7150" y="13"/>
                </a:cubicBezTo>
                <a:cubicBezTo>
                  <a:pt x="7150" y="6"/>
                  <a:pt x="7156" y="0"/>
                  <a:pt x="7163" y="0"/>
                </a:cubicBezTo>
                <a:close/>
                <a:moveTo>
                  <a:pt x="7438" y="0"/>
                </a:moveTo>
                <a:lnTo>
                  <a:pt x="7613" y="0"/>
                </a:lnTo>
                <a:cubicBezTo>
                  <a:pt x="7620" y="0"/>
                  <a:pt x="7625" y="6"/>
                  <a:pt x="7625" y="13"/>
                </a:cubicBezTo>
                <a:cubicBezTo>
                  <a:pt x="7625" y="20"/>
                  <a:pt x="7620" y="25"/>
                  <a:pt x="7613" y="25"/>
                </a:cubicBezTo>
                <a:lnTo>
                  <a:pt x="7438" y="25"/>
                </a:lnTo>
                <a:cubicBezTo>
                  <a:pt x="7431" y="25"/>
                  <a:pt x="7425" y="20"/>
                  <a:pt x="7425" y="13"/>
                </a:cubicBezTo>
                <a:cubicBezTo>
                  <a:pt x="7425" y="6"/>
                  <a:pt x="7431" y="0"/>
                  <a:pt x="7438" y="0"/>
                </a:cubicBezTo>
                <a:close/>
                <a:moveTo>
                  <a:pt x="7713" y="0"/>
                </a:moveTo>
                <a:lnTo>
                  <a:pt x="7888" y="0"/>
                </a:lnTo>
                <a:cubicBezTo>
                  <a:pt x="7895" y="0"/>
                  <a:pt x="7900" y="6"/>
                  <a:pt x="7900" y="13"/>
                </a:cubicBezTo>
                <a:cubicBezTo>
                  <a:pt x="7900" y="20"/>
                  <a:pt x="7895" y="25"/>
                  <a:pt x="7888" y="25"/>
                </a:cubicBezTo>
                <a:lnTo>
                  <a:pt x="7713" y="25"/>
                </a:lnTo>
                <a:cubicBezTo>
                  <a:pt x="7706" y="25"/>
                  <a:pt x="7700" y="20"/>
                  <a:pt x="7700" y="13"/>
                </a:cubicBezTo>
                <a:cubicBezTo>
                  <a:pt x="7700" y="6"/>
                  <a:pt x="7706" y="0"/>
                  <a:pt x="7713" y="0"/>
                </a:cubicBezTo>
                <a:close/>
                <a:moveTo>
                  <a:pt x="7988" y="0"/>
                </a:moveTo>
                <a:lnTo>
                  <a:pt x="8163" y="0"/>
                </a:lnTo>
                <a:cubicBezTo>
                  <a:pt x="8170" y="0"/>
                  <a:pt x="8175" y="6"/>
                  <a:pt x="8175" y="13"/>
                </a:cubicBezTo>
                <a:cubicBezTo>
                  <a:pt x="8175" y="20"/>
                  <a:pt x="8170" y="25"/>
                  <a:pt x="8163" y="25"/>
                </a:cubicBezTo>
                <a:lnTo>
                  <a:pt x="7988" y="25"/>
                </a:lnTo>
                <a:cubicBezTo>
                  <a:pt x="7981" y="25"/>
                  <a:pt x="7975" y="20"/>
                  <a:pt x="7975" y="13"/>
                </a:cubicBezTo>
                <a:cubicBezTo>
                  <a:pt x="7975" y="6"/>
                  <a:pt x="7981" y="0"/>
                  <a:pt x="7988" y="0"/>
                </a:cubicBezTo>
                <a:close/>
                <a:moveTo>
                  <a:pt x="8263" y="0"/>
                </a:moveTo>
                <a:lnTo>
                  <a:pt x="8438" y="0"/>
                </a:lnTo>
                <a:cubicBezTo>
                  <a:pt x="8445" y="0"/>
                  <a:pt x="8450" y="6"/>
                  <a:pt x="8450" y="13"/>
                </a:cubicBezTo>
                <a:cubicBezTo>
                  <a:pt x="8450" y="20"/>
                  <a:pt x="8445" y="25"/>
                  <a:pt x="8438" y="25"/>
                </a:cubicBezTo>
                <a:lnTo>
                  <a:pt x="8263" y="25"/>
                </a:lnTo>
                <a:cubicBezTo>
                  <a:pt x="8256" y="25"/>
                  <a:pt x="8250" y="20"/>
                  <a:pt x="8250" y="13"/>
                </a:cubicBezTo>
                <a:cubicBezTo>
                  <a:pt x="8250" y="6"/>
                  <a:pt x="8256" y="0"/>
                  <a:pt x="8263" y="0"/>
                </a:cubicBezTo>
                <a:close/>
                <a:moveTo>
                  <a:pt x="8538" y="0"/>
                </a:moveTo>
                <a:lnTo>
                  <a:pt x="8713" y="0"/>
                </a:lnTo>
                <a:cubicBezTo>
                  <a:pt x="8720" y="0"/>
                  <a:pt x="8725" y="6"/>
                  <a:pt x="8725" y="13"/>
                </a:cubicBezTo>
                <a:cubicBezTo>
                  <a:pt x="8725" y="20"/>
                  <a:pt x="8720" y="25"/>
                  <a:pt x="8713" y="25"/>
                </a:cubicBezTo>
                <a:lnTo>
                  <a:pt x="8538" y="25"/>
                </a:lnTo>
                <a:cubicBezTo>
                  <a:pt x="8531" y="25"/>
                  <a:pt x="8525" y="20"/>
                  <a:pt x="8525" y="13"/>
                </a:cubicBezTo>
                <a:cubicBezTo>
                  <a:pt x="8525" y="6"/>
                  <a:pt x="8531" y="0"/>
                  <a:pt x="8538" y="0"/>
                </a:cubicBezTo>
                <a:close/>
                <a:moveTo>
                  <a:pt x="8813" y="0"/>
                </a:moveTo>
                <a:lnTo>
                  <a:pt x="8988" y="0"/>
                </a:lnTo>
                <a:cubicBezTo>
                  <a:pt x="8995" y="0"/>
                  <a:pt x="9000" y="6"/>
                  <a:pt x="9000" y="13"/>
                </a:cubicBezTo>
                <a:cubicBezTo>
                  <a:pt x="9000" y="20"/>
                  <a:pt x="8995" y="25"/>
                  <a:pt x="8988" y="25"/>
                </a:cubicBezTo>
                <a:lnTo>
                  <a:pt x="8813" y="25"/>
                </a:lnTo>
                <a:cubicBezTo>
                  <a:pt x="8806" y="25"/>
                  <a:pt x="8800" y="20"/>
                  <a:pt x="8800" y="13"/>
                </a:cubicBezTo>
                <a:cubicBezTo>
                  <a:pt x="8800" y="6"/>
                  <a:pt x="8806" y="0"/>
                  <a:pt x="8813" y="0"/>
                </a:cubicBezTo>
                <a:close/>
                <a:moveTo>
                  <a:pt x="9088" y="0"/>
                </a:moveTo>
                <a:lnTo>
                  <a:pt x="9263" y="0"/>
                </a:lnTo>
                <a:cubicBezTo>
                  <a:pt x="9270" y="0"/>
                  <a:pt x="9275" y="6"/>
                  <a:pt x="9275" y="13"/>
                </a:cubicBezTo>
                <a:cubicBezTo>
                  <a:pt x="9275" y="20"/>
                  <a:pt x="9270" y="25"/>
                  <a:pt x="9263" y="25"/>
                </a:cubicBezTo>
                <a:lnTo>
                  <a:pt x="9088" y="25"/>
                </a:lnTo>
                <a:cubicBezTo>
                  <a:pt x="9081" y="25"/>
                  <a:pt x="9075" y="20"/>
                  <a:pt x="9075" y="13"/>
                </a:cubicBezTo>
                <a:cubicBezTo>
                  <a:pt x="9075" y="6"/>
                  <a:pt x="9081" y="0"/>
                  <a:pt x="9088" y="0"/>
                </a:cubicBezTo>
                <a:close/>
                <a:moveTo>
                  <a:pt x="9363" y="0"/>
                </a:moveTo>
                <a:lnTo>
                  <a:pt x="9538" y="0"/>
                </a:lnTo>
                <a:cubicBezTo>
                  <a:pt x="9545" y="0"/>
                  <a:pt x="9550" y="6"/>
                  <a:pt x="9550" y="13"/>
                </a:cubicBezTo>
                <a:cubicBezTo>
                  <a:pt x="9550" y="20"/>
                  <a:pt x="9545" y="25"/>
                  <a:pt x="9538" y="25"/>
                </a:cubicBezTo>
                <a:lnTo>
                  <a:pt x="9363" y="25"/>
                </a:lnTo>
                <a:cubicBezTo>
                  <a:pt x="9356" y="25"/>
                  <a:pt x="9350" y="20"/>
                  <a:pt x="9350" y="13"/>
                </a:cubicBezTo>
                <a:cubicBezTo>
                  <a:pt x="9350" y="6"/>
                  <a:pt x="9356" y="0"/>
                  <a:pt x="9363" y="0"/>
                </a:cubicBezTo>
                <a:close/>
                <a:moveTo>
                  <a:pt x="9638" y="0"/>
                </a:moveTo>
                <a:lnTo>
                  <a:pt x="9813" y="0"/>
                </a:lnTo>
                <a:cubicBezTo>
                  <a:pt x="9820" y="0"/>
                  <a:pt x="9825" y="6"/>
                  <a:pt x="9825" y="13"/>
                </a:cubicBezTo>
                <a:cubicBezTo>
                  <a:pt x="9825" y="20"/>
                  <a:pt x="9820" y="25"/>
                  <a:pt x="9813" y="25"/>
                </a:cubicBezTo>
                <a:lnTo>
                  <a:pt x="9638" y="25"/>
                </a:lnTo>
                <a:cubicBezTo>
                  <a:pt x="9631" y="25"/>
                  <a:pt x="9625" y="20"/>
                  <a:pt x="9625" y="13"/>
                </a:cubicBezTo>
                <a:cubicBezTo>
                  <a:pt x="9625" y="6"/>
                  <a:pt x="9631" y="0"/>
                  <a:pt x="9638" y="0"/>
                </a:cubicBezTo>
                <a:close/>
                <a:moveTo>
                  <a:pt x="9913" y="0"/>
                </a:moveTo>
                <a:lnTo>
                  <a:pt x="10088" y="0"/>
                </a:lnTo>
                <a:cubicBezTo>
                  <a:pt x="10095" y="0"/>
                  <a:pt x="10100" y="6"/>
                  <a:pt x="10100" y="13"/>
                </a:cubicBezTo>
                <a:cubicBezTo>
                  <a:pt x="10100" y="20"/>
                  <a:pt x="10095" y="25"/>
                  <a:pt x="10088" y="25"/>
                </a:cubicBezTo>
                <a:lnTo>
                  <a:pt x="9913" y="25"/>
                </a:lnTo>
                <a:cubicBezTo>
                  <a:pt x="9906" y="25"/>
                  <a:pt x="9900" y="20"/>
                  <a:pt x="9900" y="13"/>
                </a:cubicBezTo>
                <a:cubicBezTo>
                  <a:pt x="9900" y="6"/>
                  <a:pt x="9906" y="0"/>
                  <a:pt x="9913" y="0"/>
                </a:cubicBezTo>
                <a:close/>
                <a:moveTo>
                  <a:pt x="10188" y="0"/>
                </a:moveTo>
                <a:lnTo>
                  <a:pt x="10363" y="0"/>
                </a:lnTo>
                <a:cubicBezTo>
                  <a:pt x="10370" y="0"/>
                  <a:pt x="10375" y="6"/>
                  <a:pt x="10375" y="13"/>
                </a:cubicBezTo>
                <a:cubicBezTo>
                  <a:pt x="10375" y="20"/>
                  <a:pt x="10370" y="25"/>
                  <a:pt x="10363" y="25"/>
                </a:cubicBezTo>
                <a:lnTo>
                  <a:pt x="10188" y="25"/>
                </a:lnTo>
                <a:cubicBezTo>
                  <a:pt x="10181" y="25"/>
                  <a:pt x="10175" y="20"/>
                  <a:pt x="10175" y="13"/>
                </a:cubicBezTo>
                <a:cubicBezTo>
                  <a:pt x="10175" y="6"/>
                  <a:pt x="10181" y="0"/>
                  <a:pt x="10188" y="0"/>
                </a:cubicBezTo>
                <a:close/>
                <a:moveTo>
                  <a:pt x="10463" y="0"/>
                </a:moveTo>
                <a:lnTo>
                  <a:pt x="10638" y="0"/>
                </a:lnTo>
                <a:cubicBezTo>
                  <a:pt x="10645" y="0"/>
                  <a:pt x="10650" y="6"/>
                  <a:pt x="10650" y="13"/>
                </a:cubicBezTo>
                <a:cubicBezTo>
                  <a:pt x="10650" y="20"/>
                  <a:pt x="10645" y="25"/>
                  <a:pt x="10638" y="25"/>
                </a:cubicBezTo>
                <a:lnTo>
                  <a:pt x="10463" y="25"/>
                </a:lnTo>
                <a:cubicBezTo>
                  <a:pt x="10456" y="25"/>
                  <a:pt x="10450" y="20"/>
                  <a:pt x="10450" y="13"/>
                </a:cubicBezTo>
                <a:cubicBezTo>
                  <a:pt x="10450" y="6"/>
                  <a:pt x="10456" y="0"/>
                  <a:pt x="10463" y="0"/>
                </a:cubicBezTo>
                <a:close/>
                <a:moveTo>
                  <a:pt x="10738" y="0"/>
                </a:moveTo>
                <a:lnTo>
                  <a:pt x="10913" y="0"/>
                </a:lnTo>
                <a:cubicBezTo>
                  <a:pt x="10920" y="0"/>
                  <a:pt x="10925" y="6"/>
                  <a:pt x="10925" y="13"/>
                </a:cubicBezTo>
                <a:cubicBezTo>
                  <a:pt x="10925" y="20"/>
                  <a:pt x="10920" y="25"/>
                  <a:pt x="10913" y="25"/>
                </a:cubicBezTo>
                <a:lnTo>
                  <a:pt x="10738" y="25"/>
                </a:lnTo>
                <a:cubicBezTo>
                  <a:pt x="10731" y="25"/>
                  <a:pt x="10725" y="20"/>
                  <a:pt x="10725" y="13"/>
                </a:cubicBezTo>
                <a:cubicBezTo>
                  <a:pt x="10725" y="6"/>
                  <a:pt x="10731" y="0"/>
                  <a:pt x="10738" y="0"/>
                </a:cubicBezTo>
                <a:close/>
                <a:moveTo>
                  <a:pt x="11013" y="0"/>
                </a:moveTo>
                <a:lnTo>
                  <a:pt x="11188" y="0"/>
                </a:lnTo>
                <a:cubicBezTo>
                  <a:pt x="11195" y="0"/>
                  <a:pt x="11200" y="6"/>
                  <a:pt x="11200" y="13"/>
                </a:cubicBezTo>
                <a:cubicBezTo>
                  <a:pt x="11200" y="20"/>
                  <a:pt x="11195" y="25"/>
                  <a:pt x="11188" y="25"/>
                </a:cubicBezTo>
                <a:lnTo>
                  <a:pt x="11013" y="25"/>
                </a:lnTo>
                <a:cubicBezTo>
                  <a:pt x="11006" y="25"/>
                  <a:pt x="11000" y="20"/>
                  <a:pt x="11000" y="13"/>
                </a:cubicBezTo>
                <a:cubicBezTo>
                  <a:pt x="11000" y="6"/>
                  <a:pt x="11006" y="0"/>
                  <a:pt x="11013" y="0"/>
                </a:cubicBezTo>
                <a:close/>
                <a:moveTo>
                  <a:pt x="11288" y="0"/>
                </a:moveTo>
                <a:lnTo>
                  <a:pt x="11463" y="0"/>
                </a:lnTo>
                <a:cubicBezTo>
                  <a:pt x="11470" y="0"/>
                  <a:pt x="11475" y="6"/>
                  <a:pt x="11475" y="13"/>
                </a:cubicBezTo>
                <a:cubicBezTo>
                  <a:pt x="11475" y="20"/>
                  <a:pt x="11470" y="25"/>
                  <a:pt x="11463" y="25"/>
                </a:cubicBezTo>
                <a:lnTo>
                  <a:pt x="11288" y="25"/>
                </a:lnTo>
                <a:cubicBezTo>
                  <a:pt x="11281" y="25"/>
                  <a:pt x="11275" y="20"/>
                  <a:pt x="11275" y="13"/>
                </a:cubicBezTo>
                <a:cubicBezTo>
                  <a:pt x="11275" y="6"/>
                  <a:pt x="11281" y="0"/>
                  <a:pt x="11288" y="0"/>
                </a:cubicBezTo>
                <a:close/>
                <a:moveTo>
                  <a:pt x="11563" y="0"/>
                </a:moveTo>
                <a:lnTo>
                  <a:pt x="11738" y="0"/>
                </a:lnTo>
                <a:cubicBezTo>
                  <a:pt x="11745" y="0"/>
                  <a:pt x="11750" y="6"/>
                  <a:pt x="11750" y="13"/>
                </a:cubicBezTo>
                <a:cubicBezTo>
                  <a:pt x="11750" y="20"/>
                  <a:pt x="11745" y="25"/>
                  <a:pt x="11738" y="25"/>
                </a:cubicBezTo>
                <a:lnTo>
                  <a:pt x="11563" y="25"/>
                </a:lnTo>
                <a:cubicBezTo>
                  <a:pt x="11556" y="25"/>
                  <a:pt x="11550" y="20"/>
                  <a:pt x="11550" y="13"/>
                </a:cubicBezTo>
                <a:cubicBezTo>
                  <a:pt x="11550" y="6"/>
                  <a:pt x="11556" y="0"/>
                  <a:pt x="11563" y="0"/>
                </a:cubicBezTo>
                <a:close/>
                <a:moveTo>
                  <a:pt x="11838" y="0"/>
                </a:moveTo>
                <a:lnTo>
                  <a:pt x="12013" y="0"/>
                </a:lnTo>
                <a:cubicBezTo>
                  <a:pt x="12020" y="0"/>
                  <a:pt x="12025" y="6"/>
                  <a:pt x="12025" y="13"/>
                </a:cubicBezTo>
                <a:cubicBezTo>
                  <a:pt x="12025" y="20"/>
                  <a:pt x="12020" y="25"/>
                  <a:pt x="12013" y="25"/>
                </a:cubicBezTo>
                <a:lnTo>
                  <a:pt x="11838" y="25"/>
                </a:lnTo>
                <a:cubicBezTo>
                  <a:pt x="11831" y="25"/>
                  <a:pt x="11825" y="20"/>
                  <a:pt x="11825" y="13"/>
                </a:cubicBezTo>
                <a:cubicBezTo>
                  <a:pt x="11825" y="6"/>
                  <a:pt x="11831" y="0"/>
                  <a:pt x="11838" y="0"/>
                </a:cubicBezTo>
                <a:close/>
                <a:moveTo>
                  <a:pt x="12113" y="0"/>
                </a:moveTo>
                <a:lnTo>
                  <a:pt x="12288" y="0"/>
                </a:lnTo>
                <a:cubicBezTo>
                  <a:pt x="12295" y="0"/>
                  <a:pt x="12300" y="6"/>
                  <a:pt x="12300" y="13"/>
                </a:cubicBezTo>
                <a:cubicBezTo>
                  <a:pt x="12300" y="20"/>
                  <a:pt x="12295" y="25"/>
                  <a:pt x="12288" y="25"/>
                </a:cubicBezTo>
                <a:lnTo>
                  <a:pt x="12113" y="25"/>
                </a:lnTo>
                <a:cubicBezTo>
                  <a:pt x="12106" y="25"/>
                  <a:pt x="12100" y="20"/>
                  <a:pt x="12100" y="13"/>
                </a:cubicBezTo>
                <a:cubicBezTo>
                  <a:pt x="12100" y="6"/>
                  <a:pt x="12106" y="0"/>
                  <a:pt x="12113" y="0"/>
                </a:cubicBezTo>
                <a:close/>
                <a:moveTo>
                  <a:pt x="12388" y="0"/>
                </a:moveTo>
                <a:lnTo>
                  <a:pt x="12563" y="0"/>
                </a:lnTo>
                <a:cubicBezTo>
                  <a:pt x="12570" y="0"/>
                  <a:pt x="12575" y="6"/>
                  <a:pt x="12575" y="13"/>
                </a:cubicBezTo>
                <a:cubicBezTo>
                  <a:pt x="12575" y="20"/>
                  <a:pt x="12570" y="25"/>
                  <a:pt x="12563" y="25"/>
                </a:cubicBezTo>
                <a:lnTo>
                  <a:pt x="12388" y="25"/>
                </a:lnTo>
                <a:cubicBezTo>
                  <a:pt x="12381" y="25"/>
                  <a:pt x="12375" y="20"/>
                  <a:pt x="12375" y="13"/>
                </a:cubicBezTo>
                <a:cubicBezTo>
                  <a:pt x="12375" y="6"/>
                  <a:pt x="12381" y="0"/>
                  <a:pt x="12388" y="0"/>
                </a:cubicBezTo>
                <a:close/>
                <a:moveTo>
                  <a:pt x="12663" y="0"/>
                </a:moveTo>
                <a:lnTo>
                  <a:pt x="12838" y="0"/>
                </a:lnTo>
                <a:cubicBezTo>
                  <a:pt x="12845" y="0"/>
                  <a:pt x="12850" y="6"/>
                  <a:pt x="12850" y="13"/>
                </a:cubicBezTo>
                <a:cubicBezTo>
                  <a:pt x="12850" y="20"/>
                  <a:pt x="12845" y="25"/>
                  <a:pt x="12838" y="25"/>
                </a:cubicBezTo>
                <a:lnTo>
                  <a:pt x="12663" y="25"/>
                </a:lnTo>
                <a:cubicBezTo>
                  <a:pt x="12656" y="25"/>
                  <a:pt x="12650" y="20"/>
                  <a:pt x="12650" y="13"/>
                </a:cubicBezTo>
                <a:cubicBezTo>
                  <a:pt x="12650" y="6"/>
                  <a:pt x="12656" y="0"/>
                  <a:pt x="12663" y="0"/>
                </a:cubicBezTo>
                <a:close/>
                <a:moveTo>
                  <a:pt x="12938" y="0"/>
                </a:moveTo>
                <a:lnTo>
                  <a:pt x="13113" y="0"/>
                </a:lnTo>
                <a:cubicBezTo>
                  <a:pt x="13120" y="0"/>
                  <a:pt x="13125" y="6"/>
                  <a:pt x="13125" y="13"/>
                </a:cubicBezTo>
                <a:cubicBezTo>
                  <a:pt x="13125" y="20"/>
                  <a:pt x="13120" y="25"/>
                  <a:pt x="13113" y="25"/>
                </a:cubicBezTo>
                <a:lnTo>
                  <a:pt x="12938" y="25"/>
                </a:lnTo>
                <a:cubicBezTo>
                  <a:pt x="12931" y="25"/>
                  <a:pt x="12925" y="20"/>
                  <a:pt x="12925" y="13"/>
                </a:cubicBezTo>
                <a:cubicBezTo>
                  <a:pt x="12925" y="6"/>
                  <a:pt x="12931" y="0"/>
                  <a:pt x="12938" y="0"/>
                </a:cubicBezTo>
                <a:close/>
                <a:moveTo>
                  <a:pt x="13213" y="0"/>
                </a:moveTo>
                <a:lnTo>
                  <a:pt x="13388" y="0"/>
                </a:lnTo>
                <a:cubicBezTo>
                  <a:pt x="13395" y="0"/>
                  <a:pt x="13400" y="6"/>
                  <a:pt x="13400" y="13"/>
                </a:cubicBezTo>
                <a:cubicBezTo>
                  <a:pt x="13400" y="20"/>
                  <a:pt x="13395" y="25"/>
                  <a:pt x="13388" y="25"/>
                </a:cubicBezTo>
                <a:lnTo>
                  <a:pt x="13213" y="25"/>
                </a:lnTo>
                <a:cubicBezTo>
                  <a:pt x="13206" y="25"/>
                  <a:pt x="13200" y="20"/>
                  <a:pt x="13200" y="13"/>
                </a:cubicBezTo>
                <a:cubicBezTo>
                  <a:pt x="13200" y="6"/>
                  <a:pt x="13206" y="0"/>
                  <a:pt x="13213" y="0"/>
                </a:cubicBezTo>
                <a:close/>
                <a:moveTo>
                  <a:pt x="13488" y="0"/>
                </a:moveTo>
                <a:lnTo>
                  <a:pt x="13663" y="0"/>
                </a:lnTo>
                <a:cubicBezTo>
                  <a:pt x="13670" y="0"/>
                  <a:pt x="13675" y="6"/>
                  <a:pt x="13675" y="13"/>
                </a:cubicBezTo>
                <a:cubicBezTo>
                  <a:pt x="13675" y="20"/>
                  <a:pt x="13670" y="25"/>
                  <a:pt x="13663" y="25"/>
                </a:cubicBezTo>
                <a:lnTo>
                  <a:pt x="13488" y="25"/>
                </a:lnTo>
                <a:cubicBezTo>
                  <a:pt x="13481" y="25"/>
                  <a:pt x="13475" y="20"/>
                  <a:pt x="13475" y="13"/>
                </a:cubicBezTo>
                <a:cubicBezTo>
                  <a:pt x="13475" y="6"/>
                  <a:pt x="13481" y="0"/>
                  <a:pt x="13488" y="0"/>
                </a:cubicBezTo>
                <a:close/>
                <a:moveTo>
                  <a:pt x="13763" y="0"/>
                </a:moveTo>
                <a:lnTo>
                  <a:pt x="13813" y="0"/>
                </a:lnTo>
                <a:cubicBezTo>
                  <a:pt x="13820" y="0"/>
                  <a:pt x="13825" y="6"/>
                  <a:pt x="13825" y="13"/>
                </a:cubicBezTo>
                <a:cubicBezTo>
                  <a:pt x="13825" y="20"/>
                  <a:pt x="13820" y="25"/>
                  <a:pt x="13813" y="25"/>
                </a:cubicBezTo>
                <a:lnTo>
                  <a:pt x="13763" y="25"/>
                </a:lnTo>
                <a:cubicBezTo>
                  <a:pt x="13756" y="25"/>
                  <a:pt x="13750" y="20"/>
                  <a:pt x="13750" y="13"/>
                </a:cubicBezTo>
                <a:cubicBezTo>
                  <a:pt x="13750" y="6"/>
                  <a:pt x="13756" y="0"/>
                  <a:pt x="13763" y="0"/>
                </a:cubicBezTo>
                <a:close/>
              </a:path>
            </a:pathLst>
          </a:custGeom>
          <a:solidFill>
            <a:srgbClr val="969696"/>
          </a:solidFill>
          <a:ln w="1440">
            <a:solidFill>
              <a:srgbClr val="969696"/>
            </a:solidFill>
            <a:bevel/>
          </a:ln>
        </p:spPr>
        <p:style>
          <a:lnRef idx="0"/>
          <a:fillRef idx="0"/>
          <a:effectRef idx="0"/>
          <a:fontRef idx="minor"/>
        </p:style>
        <p:txBody>
          <a:bodyPr lIns="90000" rIns="90000" tIns="-40680" bIns="-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13" name=""/>
          <p:cNvGrpSpPr/>
          <p:nvPr/>
        </p:nvGrpSpPr>
        <p:grpSpPr>
          <a:xfrm>
            <a:off x="1422360" y="5249880"/>
            <a:ext cx="63720" cy="63360"/>
            <a:chOff x="1422360" y="5249880"/>
            <a:chExt cx="63720" cy="63360"/>
          </a:xfrm>
        </p:grpSpPr>
        <p:sp>
          <p:nvSpPr>
            <p:cNvPr id="114" name=""/>
            <p:cNvSpPr/>
            <p:nvPr/>
          </p:nvSpPr>
          <p:spPr>
            <a:xfrm>
              <a:off x="1422360" y="5249880"/>
              <a:ext cx="63720" cy="63360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" bIns="-1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"/>
            <p:cNvSpPr/>
            <p:nvPr/>
          </p:nvSpPr>
          <p:spPr>
            <a:xfrm>
              <a:off x="1422360" y="5249880"/>
              <a:ext cx="63720" cy="63360"/>
            </a:xfrm>
            <a:prstGeom prst="ellipse">
              <a:avLst/>
            </a:prstGeom>
            <a:noFill/>
            <a:ln cap="rnd"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" bIns="-1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16" name=""/>
          <p:cNvGrpSpPr/>
          <p:nvPr/>
        </p:nvGrpSpPr>
        <p:grpSpPr>
          <a:xfrm>
            <a:off x="1422360" y="5334120"/>
            <a:ext cx="63720" cy="63360"/>
            <a:chOff x="1422360" y="5334120"/>
            <a:chExt cx="63720" cy="63360"/>
          </a:xfrm>
        </p:grpSpPr>
        <p:sp>
          <p:nvSpPr>
            <p:cNvPr id="117" name=""/>
            <p:cNvSpPr/>
            <p:nvPr/>
          </p:nvSpPr>
          <p:spPr>
            <a:xfrm>
              <a:off x="1422360" y="5334120"/>
              <a:ext cx="63720" cy="63360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" bIns="-1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"/>
            <p:cNvSpPr/>
            <p:nvPr/>
          </p:nvSpPr>
          <p:spPr>
            <a:xfrm>
              <a:off x="1422360" y="5334120"/>
              <a:ext cx="63720" cy="63360"/>
            </a:xfrm>
            <a:prstGeom prst="ellipse">
              <a:avLst/>
            </a:prstGeom>
            <a:noFill/>
            <a:ln cap="rnd"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" bIns="-1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19" name=""/>
          <p:cNvGrpSpPr/>
          <p:nvPr/>
        </p:nvGrpSpPr>
        <p:grpSpPr>
          <a:xfrm>
            <a:off x="1422360" y="5460840"/>
            <a:ext cx="63720" cy="63360"/>
            <a:chOff x="1422360" y="5460840"/>
            <a:chExt cx="63720" cy="63360"/>
          </a:xfrm>
        </p:grpSpPr>
        <p:sp>
          <p:nvSpPr>
            <p:cNvPr id="120" name=""/>
            <p:cNvSpPr/>
            <p:nvPr/>
          </p:nvSpPr>
          <p:spPr>
            <a:xfrm>
              <a:off x="1422360" y="5460840"/>
              <a:ext cx="63720" cy="63360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" bIns="-1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"/>
            <p:cNvSpPr/>
            <p:nvPr/>
          </p:nvSpPr>
          <p:spPr>
            <a:xfrm>
              <a:off x="1422360" y="5460840"/>
              <a:ext cx="63720" cy="63360"/>
            </a:xfrm>
            <a:prstGeom prst="ellipse">
              <a:avLst/>
            </a:prstGeom>
            <a:noFill/>
            <a:ln cap="rnd"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" bIns="-1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22" name=""/>
          <p:cNvGrpSpPr/>
          <p:nvPr/>
        </p:nvGrpSpPr>
        <p:grpSpPr>
          <a:xfrm>
            <a:off x="3138480" y="5249880"/>
            <a:ext cx="63360" cy="63360"/>
            <a:chOff x="3138480" y="5249880"/>
            <a:chExt cx="63360" cy="63360"/>
          </a:xfrm>
        </p:grpSpPr>
        <p:sp>
          <p:nvSpPr>
            <p:cNvPr id="123" name=""/>
            <p:cNvSpPr/>
            <p:nvPr/>
          </p:nvSpPr>
          <p:spPr>
            <a:xfrm>
              <a:off x="3138480" y="5249880"/>
              <a:ext cx="63360" cy="63360"/>
            </a:xfrm>
            <a:prstGeom prst="ellipse">
              <a:avLst/>
            </a:prstGeom>
            <a:solidFill>
              <a:srgbClr val="969696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" bIns="-1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"/>
            <p:cNvSpPr/>
            <p:nvPr/>
          </p:nvSpPr>
          <p:spPr>
            <a:xfrm>
              <a:off x="3138480" y="5249880"/>
              <a:ext cx="63360" cy="63360"/>
            </a:xfrm>
            <a:prstGeom prst="ellipse">
              <a:avLst/>
            </a:prstGeom>
            <a:noFill/>
            <a:ln cap="rnd"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" bIns="-1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25" name=""/>
          <p:cNvGrpSpPr/>
          <p:nvPr/>
        </p:nvGrpSpPr>
        <p:grpSpPr>
          <a:xfrm>
            <a:off x="3138480" y="5376960"/>
            <a:ext cx="63360" cy="63360"/>
            <a:chOff x="3138480" y="5376960"/>
            <a:chExt cx="63360" cy="63360"/>
          </a:xfrm>
        </p:grpSpPr>
        <p:sp>
          <p:nvSpPr>
            <p:cNvPr id="126" name=""/>
            <p:cNvSpPr/>
            <p:nvPr/>
          </p:nvSpPr>
          <p:spPr>
            <a:xfrm>
              <a:off x="3138480" y="5376960"/>
              <a:ext cx="63360" cy="63360"/>
            </a:xfrm>
            <a:prstGeom prst="ellipse">
              <a:avLst/>
            </a:prstGeom>
            <a:solidFill>
              <a:srgbClr val="969696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" bIns="-1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"/>
            <p:cNvSpPr/>
            <p:nvPr/>
          </p:nvSpPr>
          <p:spPr>
            <a:xfrm>
              <a:off x="3138480" y="5376960"/>
              <a:ext cx="63360" cy="63360"/>
            </a:xfrm>
            <a:prstGeom prst="ellipse">
              <a:avLst/>
            </a:prstGeom>
            <a:noFill/>
            <a:ln cap="rnd"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" bIns="-1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28" name=""/>
          <p:cNvGrpSpPr/>
          <p:nvPr/>
        </p:nvGrpSpPr>
        <p:grpSpPr>
          <a:xfrm>
            <a:off x="3138480" y="5334120"/>
            <a:ext cx="63360" cy="63360"/>
            <a:chOff x="3138480" y="5334120"/>
            <a:chExt cx="63360" cy="63360"/>
          </a:xfrm>
        </p:grpSpPr>
        <p:sp>
          <p:nvSpPr>
            <p:cNvPr id="129" name=""/>
            <p:cNvSpPr/>
            <p:nvPr/>
          </p:nvSpPr>
          <p:spPr>
            <a:xfrm>
              <a:off x="3138480" y="5334120"/>
              <a:ext cx="63360" cy="63360"/>
            </a:xfrm>
            <a:prstGeom prst="ellipse">
              <a:avLst/>
            </a:prstGeom>
            <a:solidFill>
              <a:srgbClr val="969696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" bIns="-1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"/>
            <p:cNvSpPr/>
            <p:nvPr/>
          </p:nvSpPr>
          <p:spPr>
            <a:xfrm>
              <a:off x="3138480" y="5334120"/>
              <a:ext cx="63360" cy="63360"/>
            </a:xfrm>
            <a:prstGeom prst="ellipse">
              <a:avLst/>
            </a:prstGeom>
            <a:noFill/>
            <a:ln cap="rnd"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" bIns="-1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31" name=""/>
          <p:cNvGrpSpPr/>
          <p:nvPr/>
        </p:nvGrpSpPr>
        <p:grpSpPr>
          <a:xfrm>
            <a:off x="3138480" y="5460840"/>
            <a:ext cx="63360" cy="63360"/>
            <a:chOff x="3138480" y="5460840"/>
            <a:chExt cx="63360" cy="63360"/>
          </a:xfrm>
        </p:grpSpPr>
        <p:sp>
          <p:nvSpPr>
            <p:cNvPr id="132" name=""/>
            <p:cNvSpPr/>
            <p:nvPr/>
          </p:nvSpPr>
          <p:spPr>
            <a:xfrm>
              <a:off x="3138480" y="5460840"/>
              <a:ext cx="63360" cy="63360"/>
            </a:xfrm>
            <a:prstGeom prst="ellipse">
              <a:avLst/>
            </a:prstGeom>
            <a:solidFill>
              <a:srgbClr val="969696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" bIns="-1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"/>
            <p:cNvSpPr/>
            <p:nvPr/>
          </p:nvSpPr>
          <p:spPr>
            <a:xfrm>
              <a:off x="3138480" y="5460840"/>
              <a:ext cx="63360" cy="63360"/>
            </a:xfrm>
            <a:prstGeom prst="ellipse">
              <a:avLst/>
            </a:prstGeom>
            <a:noFill/>
            <a:ln cap="rnd"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" bIns="-1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34" name=""/>
          <p:cNvGrpSpPr/>
          <p:nvPr/>
        </p:nvGrpSpPr>
        <p:grpSpPr>
          <a:xfrm>
            <a:off x="3579840" y="5164200"/>
            <a:ext cx="63360" cy="63360"/>
            <a:chOff x="3579840" y="5164200"/>
            <a:chExt cx="63360" cy="63360"/>
          </a:xfrm>
        </p:grpSpPr>
        <p:sp>
          <p:nvSpPr>
            <p:cNvPr id="135" name=""/>
            <p:cNvSpPr/>
            <p:nvPr/>
          </p:nvSpPr>
          <p:spPr>
            <a:xfrm>
              <a:off x="3579840" y="5164200"/>
              <a:ext cx="63360" cy="63360"/>
            </a:xfrm>
            <a:prstGeom prst="ellipse">
              <a:avLst/>
            </a:prstGeom>
            <a:solidFill>
              <a:srgbClr val="c0c0c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" bIns="-1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"/>
            <p:cNvSpPr/>
            <p:nvPr/>
          </p:nvSpPr>
          <p:spPr>
            <a:xfrm>
              <a:off x="3579840" y="5164200"/>
              <a:ext cx="63360" cy="63360"/>
            </a:xfrm>
            <a:prstGeom prst="ellipse">
              <a:avLst/>
            </a:prstGeom>
            <a:noFill/>
            <a:ln cap="rnd" w="1440">
              <a:solidFill>
                <a:srgbClr val="c0c0c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" bIns="-1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37" name=""/>
          <p:cNvGrpSpPr/>
          <p:nvPr/>
        </p:nvGrpSpPr>
        <p:grpSpPr>
          <a:xfrm>
            <a:off x="3579840" y="5249880"/>
            <a:ext cx="63360" cy="63360"/>
            <a:chOff x="3579840" y="5249880"/>
            <a:chExt cx="63360" cy="63360"/>
          </a:xfrm>
        </p:grpSpPr>
        <p:sp>
          <p:nvSpPr>
            <p:cNvPr id="138" name=""/>
            <p:cNvSpPr/>
            <p:nvPr/>
          </p:nvSpPr>
          <p:spPr>
            <a:xfrm>
              <a:off x="3579840" y="5249880"/>
              <a:ext cx="63360" cy="63360"/>
            </a:xfrm>
            <a:prstGeom prst="ellipse">
              <a:avLst/>
            </a:prstGeom>
            <a:solidFill>
              <a:srgbClr val="c0c0c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" bIns="-1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"/>
            <p:cNvSpPr/>
            <p:nvPr/>
          </p:nvSpPr>
          <p:spPr>
            <a:xfrm>
              <a:off x="3579840" y="5249880"/>
              <a:ext cx="63360" cy="63360"/>
            </a:xfrm>
            <a:prstGeom prst="ellipse">
              <a:avLst/>
            </a:prstGeom>
            <a:noFill/>
            <a:ln cap="rnd" w="1440">
              <a:solidFill>
                <a:srgbClr val="c0c0c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" bIns="-1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40" name=""/>
          <p:cNvGrpSpPr/>
          <p:nvPr/>
        </p:nvGrpSpPr>
        <p:grpSpPr>
          <a:xfrm>
            <a:off x="3579840" y="5376960"/>
            <a:ext cx="63360" cy="63360"/>
            <a:chOff x="3579840" y="5376960"/>
            <a:chExt cx="63360" cy="63360"/>
          </a:xfrm>
        </p:grpSpPr>
        <p:sp>
          <p:nvSpPr>
            <p:cNvPr id="141" name=""/>
            <p:cNvSpPr/>
            <p:nvPr/>
          </p:nvSpPr>
          <p:spPr>
            <a:xfrm>
              <a:off x="3579840" y="5376960"/>
              <a:ext cx="63360" cy="63360"/>
            </a:xfrm>
            <a:prstGeom prst="ellipse">
              <a:avLst/>
            </a:prstGeom>
            <a:solidFill>
              <a:srgbClr val="c0c0c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" bIns="-1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"/>
            <p:cNvSpPr/>
            <p:nvPr/>
          </p:nvSpPr>
          <p:spPr>
            <a:xfrm>
              <a:off x="3579840" y="5376960"/>
              <a:ext cx="63360" cy="63360"/>
            </a:xfrm>
            <a:prstGeom prst="ellipse">
              <a:avLst/>
            </a:prstGeom>
            <a:noFill/>
            <a:ln cap="rnd" w="1440">
              <a:solidFill>
                <a:srgbClr val="c0c0c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" bIns="-1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43" name=""/>
          <p:cNvSpPr/>
          <p:nvPr/>
        </p:nvSpPr>
        <p:spPr>
          <a:xfrm>
            <a:off x="703800" y="5438880"/>
            <a:ext cx="19584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0.1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"/>
          <p:cNvSpPr/>
          <p:nvPr/>
        </p:nvSpPr>
        <p:spPr>
          <a:xfrm>
            <a:off x="2982960" y="6012000"/>
            <a:ext cx="1079280" cy="0"/>
          </a:xfrm>
          <a:prstGeom prst="line">
            <a:avLst/>
          </a:prstGeom>
          <a:ln cap="rnd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"/>
          <p:cNvSpPr/>
          <p:nvPr/>
        </p:nvSpPr>
        <p:spPr>
          <a:xfrm>
            <a:off x="1015920" y="6012000"/>
            <a:ext cx="1800360" cy="0"/>
          </a:xfrm>
          <a:prstGeom prst="line">
            <a:avLst/>
          </a:prstGeom>
          <a:ln cap="rnd"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"/>
          <p:cNvSpPr/>
          <p:nvPr/>
        </p:nvSpPr>
        <p:spPr>
          <a:xfrm>
            <a:off x="1289520" y="6048360"/>
            <a:ext cx="125496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Conditioned Media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"/>
          <p:cNvSpPr/>
          <p:nvPr/>
        </p:nvSpPr>
        <p:spPr>
          <a:xfrm rot="16200000">
            <a:off x="3067920" y="2028960"/>
            <a:ext cx="3297240" cy="36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500" spc="-1" strike="noStrike">
                <a:solidFill>
                  <a:srgbClr val="000000"/>
                </a:solidFill>
                <a:latin typeface="Arial"/>
              </a:rPr>
              <a:t>       </a:t>
            </a:r>
            <a:r>
              <a:rPr b="1" i="1" lang="en-US" sz="1500" spc="-1" strike="noStrike">
                <a:solidFill>
                  <a:srgbClr val="000000"/>
                </a:solidFill>
                <a:latin typeface="Arial"/>
              </a:rPr>
              <a:t>Wnt-5a</a:t>
            </a:r>
            <a:r>
              <a:rPr b="1" lang="en-US" sz="1500" spc="-1" strike="noStrike">
                <a:solidFill>
                  <a:srgbClr val="000000"/>
                </a:solidFill>
                <a:latin typeface="Arial"/>
              </a:rPr>
              <a:t> intensity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500" spc="-1" strike="noStrike">
                <a:solidFill>
                  <a:srgbClr val="000000"/>
                </a:solidFill>
                <a:latin typeface="Arial"/>
              </a:rPr>
              <a:t>       </a:t>
            </a:r>
            <a:r>
              <a:rPr b="0" lang="en-US" sz="1500" spc="-1" strike="noStrike">
                <a:solidFill>
                  <a:srgbClr val="000000"/>
                </a:solidFill>
                <a:latin typeface="Arial"/>
              </a:rPr>
              <a:t>(relative units)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"/>
          <p:cNvSpPr/>
          <p:nvPr/>
        </p:nvSpPr>
        <p:spPr>
          <a:xfrm>
            <a:off x="4921920" y="3184560"/>
            <a:ext cx="90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"/>
          <p:cNvSpPr/>
          <p:nvPr/>
        </p:nvSpPr>
        <p:spPr>
          <a:xfrm>
            <a:off x="4915800" y="1833480"/>
            <a:ext cx="90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"/>
          <p:cNvSpPr/>
          <p:nvPr/>
        </p:nvSpPr>
        <p:spPr>
          <a:xfrm>
            <a:off x="5035680" y="3319560"/>
            <a:ext cx="42840" cy="7920"/>
          </a:xfrm>
          <a:prstGeom prst="rect">
            <a:avLst/>
          </a:prstGeom>
          <a:solidFill>
            <a:srgbClr val="000000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"/>
          <p:cNvSpPr/>
          <p:nvPr/>
        </p:nvSpPr>
        <p:spPr>
          <a:xfrm>
            <a:off x="5035680" y="1938240"/>
            <a:ext cx="42840" cy="14400"/>
          </a:xfrm>
          <a:prstGeom prst="rect">
            <a:avLst/>
          </a:prstGeom>
          <a:solidFill>
            <a:srgbClr val="000000"/>
          </a:solidFill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2400" bIns="-32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"/>
          <p:cNvSpPr/>
          <p:nvPr/>
        </p:nvSpPr>
        <p:spPr>
          <a:xfrm>
            <a:off x="5045040" y="2630520"/>
            <a:ext cx="31680" cy="1116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"/>
          <p:cNvSpPr/>
          <p:nvPr/>
        </p:nvSpPr>
        <p:spPr>
          <a:xfrm>
            <a:off x="5256360" y="1940040"/>
            <a:ext cx="257040" cy="1385640"/>
          </a:xfrm>
          <a:prstGeom prst="rect">
            <a:avLst/>
          </a:prstGeom>
          <a:solidFill>
            <a:srgbClr val="ffffff"/>
          </a:solidFill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"/>
          <p:cNvSpPr/>
          <p:nvPr/>
        </p:nvSpPr>
        <p:spPr>
          <a:xfrm>
            <a:off x="5256360" y="3600360"/>
            <a:ext cx="258480" cy="180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"/>
          <p:cNvSpPr/>
          <p:nvPr/>
        </p:nvSpPr>
        <p:spPr>
          <a:xfrm>
            <a:off x="5767560" y="3600360"/>
            <a:ext cx="900000" cy="180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"/>
          <p:cNvSpPr/>
          <p:nvPr/>
        </p:nvSpPr>
        <p:spPr>
          <a:xfrm>
            <a:off x="5078520" y="793800"/>
            <a:ext cx="1608120" cy="2533680"/>
          </a:xfrm>
          <a:custGeom>
            <a:avLst/>
            <a:gdLst/>
            <a:ahLst/>
            <a:rect l="l" t="t" r="r" b="b"/>
            <a:pathLst>
              <a:path w="1010" h="937">
                <a:moveTo>
                  <a:pt x="0" y="0"/>
                </a:moveTo>
                <a:lnTo>
                  <a:pt x="0" y="937"/>
                </a:lnTo>
                <a:lnTo>
                  <a:pt x="1010" y="937"/>
                </a:lnTo>
              </a:path>
            </a:pathLst>
          </a:custGeom>
          <a:noFill/>
          <a:ln w="208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"/>
          <p:cNvSpPr/>
          <p:nvPr/>
        </p:nvSpPr>
        <p:spPr>
          <a:xfrm>
            <a:off x="5023800" y="3591000"/>
            <a:ext cx="721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ontro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"/>
          <p:cNvSpPr/>
          <p:nvPr/>
        </p:nvSpPr>
        <p:spPr>
          <a:xfrm>
            <a:off x="5657040" y="3591000"/>
            <a:ext cx="1172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</a:t>
            </a:r>
            <a:r>
              <a:rPr b="1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 Oligomer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"/>
          <p:cNvSpPr/>
          <p:nvPr/>
        </p:nvSpPr>
        <p:spPr>
          <a:xfrm>
            <a:off x="5704200" y="336384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5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"/>
          <p:cNvSpPr/>
          <p:nvPr/>
        </p:nvSpPr>
        <p:spPr>
          <a:xfrm>
            <a:off x="6006600" y="3363840"/>
            <a:ext cx="799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500 (nM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"/>
          <p:cNvSpPr/>
          <p:nvPr/>
        </p:nvSpPr>
        <p:spPr>
          <a:xfrm>
            <a:off x="5751360" y="1916280"/>
            <a:ext cx="257400" cy="1409400"/>
          </a:xfrm>
          <a:prstGeom prst="rect">
            <a:avLst/>
          </a:prstGeom>
          <a:solidFill>
            <a:srgbClr val="1c1c1c"/>
          </a:solidFill>
          <a:ln w="208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62" name=""/>
          <p:cNvGrpSpPr/>
          <p:nvPr/>
        </p:nvGrpSpPr>
        <p:grpSpPr>
          <a:xfrm>
            <a:off x="5824440" y="1700280"/>
            <a:ext cx="109800" cy="290520"/>
            <a:chOff x="5824440" y="1700280"/>
            <a:chExt cx="109800" cy="290520"/>
          </a:xfrm>
        </p:grpSpPr>
        <p:sp>
          <p:nvSpPr>
            <p:cNvPr id="163" name=""/>
            <p:cNvSpPr/>
            <p:nvPr/>
          </p:nvSpPr>
          <p:spPr>
            <a:xfrm>
              <a:off x="5878440" y="1700280"/>
              <a:ext cx="1800" cy="2905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"/>
            <p:cNvSpPr/>
            <p:nvPr/>
          </p:nvSpPr>
          <p:spPr>
            <a:xfrm>
              <a:off x="5824440" y="1700280"/>
              <a:ext cx="10980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65" name=""/>
          <p:cNvSpPr/>
          <p:nvPr/>
        </p:nvSpPr>
        <p:spPr>
          <a:xfrm>
            <a:off x="6246720" y="1844640"/>
            <a:ext cx="257400" cy="1481040"/>
          </a:xfrm>
          <a:prstGeom prst="rect">
            <a:avLst/>
          </a:prstGeom>
          <a:solidFill>
            <a:srgbClr val="000000"/>
          </a:solidFill>
          <a:ln w="208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66" name=""/>
          <p:cNvGrpSpPr/>
          <p:nvPr/>
        </p:nvGrpSpPr>
        <p:grpSpPr>
          <a:xfrm>
            <a:off x="6319800" y="1585800"/>
            <a:ext cx="109440" cy="258840"/>
            <a:chOff x="6319800" y="1585800"/>
            <a:chExt cx="109440" cy="258840"/>
          </a:xfrm>
        </p:grpSpPr>
        <p:sp>
          <p:nvSpPr>
            <p:cNvPr id="167" name=""/>
            <p:cNvSpPr/>
            <p:nvPr/>
          </p:nvSpPr>
          <p:spPr>
            <a:xfrm>
              <a:off x="6373800" y="1585800"/>
              <a:ext cx="1440" cy="2588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"/>
            <p:cNvSpPr/>
            <p:nvPr/>
          </p:nvSpPr>
          <p:spPr>
            <a:xfrm>
              <a:off x="6319800" y="1585800"/>
              <a:ext cx="1094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69" name=""/>
          <p:cNvSpPr/>
          <p:nvPr/>
        </p:nvSpPr>
        <p:spPr>
          <a:xfrm>
            <a:off x="5045040" y="1249200"/>
            <a:ext cx="33480" cy="1116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70" name=""/>
          <p:cNvGrpSpPr/>
          <p:nvPr/>
        </p:nvGrpSpPr>
        <p:grpSpPr>
          <a:xfrm>
            <a:off x="1422360" y="5376960"/>
            <a:ext cx="63720" cy="63360"/>
            <a:chOff x="1422360" y="5376960"/>
            <a:chExt cx="63720" cy="63360"/>
          </a:xfrm>
        </p:grpSpPr>
        <p:sp>
          <p:nvSpPr>
            <p:cNvPr id="171" name=""/>
            <p:cNvSpPr/>
            <p:nvPr/>
          </p:nvSpPr>
          <p:spPr>
            <a:xfrm>
              <a:off x="1422360" y="5376960"/>
              <a:ext cx="63720" cy="63360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" bIns="-1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"/>
            <p:cNvSpPr/>
            <p:nvPr/>
          </p:nvSpPr>
          <p:spPr>
            <a:xfrm>
              <a:off x="1422360" y="5376960"/>
              <a:ext cx="63720" cy="63360"/>
            </a:xfrm>
            <a:prstGeom prst="ellipse">
              <a:avLst/>
            </a:prstGeom>
            <a:noFill/>
            <a:ln cap="rnd"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" bIns="-1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73" name=""/>
          <p:cNvGrpSpPr/>
          <p:nvPr/>
        </p:nvGrpSpPr>
        <p:grpSpPr>
          <a:xfrm>
            <a:off x="3579840" y="5291280"/>
            <a:ext cx="63360" cy="63360"/>
            <a:chOff x="3579840" y="5291280"/>
            <a:chExt cx="63360" cy="63360"/>
          </a:xfrm>
        </p:grpSpPr>
        <p:sp>
          <p:nvSpPr>
            <p:cNvPr id="174" name=""/>
            <p:cNvSpPr/>
            <p:nvPr/>
          </p:nvSpPr>
          <p:spPr>
            <a:xfrm>
              <a:off x="3579840" y="5291280"/>
              <a:ext cx="63360" cy="63360"/>
            </a:xfrm>
            <a:prstGeom prst="ellipse">
              <a:avLst/>
            </a:prstGeom>
            <a:solidFill>
              <a:srgbClr val="c0c0c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" bIns="-1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"/>
            <p:cNvSpPr/>
            <p:nvPr/>
          </p:nvSpPr>
          <p:spPr>
            <a:xfrm>
              <a:off x="3579840" y="5291280"/>
              <a:ext cx="63360" cy="63360"/>
            </a:xfrm>
            <a:prstGeom prst="ellipse">
              <a:avLst/>
            </a:prstGeom>
            <a:noFill/>
            <a:ln cap="rnd" w="1440">
              <a:solidFill>
                <a:srgbClr val="c0c0c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" bIns="-1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76" name=""/>
          <p:cNvSpPr/>
          <p:nvPr/>
        </p:nvSpPr>
        <p:spPr>
          <a:xfrm>
            <a:off x="465480" y="700200"/>
            <a:ext cx="307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ffff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"/>
          <p:cNvSpPr/>
          <p:nvPr/>
        </p:nvSpPr>
        <p:spPr>
          <a:xfrm>
            <a:off x="3044520" y="700200"/>
            <a:ext cx="295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ffff"/>
                </a:solidFill>
                <a:latin typeface="Arial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"/>
          <p:cNvSpPr/>
          <p:nvPr/>
        </p:nvSpPr>
        <p:spPr>
          <a:xfrm>
            <a:off x="1754640" y="700200"/>
            <a:ext cx="307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ffff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"/>
          <p:cNvSpPr/>
          <p:nvPr/>
        </p:nvSpPr>
        <p:spPr>
          <a:xfrm>
            <a:off x="465480" y="1998720"/>
            <a:ext cx="307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ffff"/>
                </a:solidFill>
                <a:latin typeface="Arial"/>
              </a:rPr>
              <a:t>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"/>
          <p:cNvSpPr/>
          <p:nvPr/>
        </p:nvSpPr>
        <p:spPr>
          <a:xfrm>
            <a:off x="3044520" y="1998720"/>
            <a:ext cx="244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ffff"/>
                </a:solidFill>
                <a:latin typeface="Arial"/>
              </a:rPr>
              <a:t>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"/>
          <p:cNvSpPr/>
          <p:nvPr/>
        </p:nvSpPr>
        <p:spPr>
          <a:xfrm>
            <a:off x="1754640" y="1998720"/>
            <a:ext cx="307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ffff"/>
                </a:solidFill>
                <a:latin typeface="Arial"/>
              </a:rPr>
              <a:t>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"/>
          <p:cNvSpPr/>
          <p:nvPr/>
        </p:nvSpPr>
        <p:spPr>
          <a:xfrm>
            <a:off x="1814400" y="3597120"/>
            <a:ext cx="2519640" cy="180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"/>
          <p:cNvSpPr/>
          <p:nvPr/>
        </p:nvSpPr>
        <p:spPr>
          <a:xfrm>
            <a:off x="2305440" y="3591000"/>
            <a:ext cx="1535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</a:t>
            </a:r>
            <a:r>
              <a:rPr b="1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 Oligomers (nM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1-28T13:06:03Z</dcterms:created>
  <dc:creator>Waldo</dc:creator>
  <dc:description/>
  <dc:language>en-US</dc:language>
  <cp:lastModifiedBy>Waldo</cp:lastModifiedBy>
  <dcterms:modified xsi:type="dcterms:W3CDTF">2010-01-05T13:17:58Z</dcterms:modified>
  <cp:revision>4</cp:revision>
  <dc:subject/>
  <dc:title>Diapositiva 1</dc:title>
</cp:coreProperties>
</file>